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78" d="100"/>
          <a:sy n="78" d="100"/>
        </p:scale>
        <p:origin x="78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44F19B-691F-774E-8289-7D1B8F7FBA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6F43225-CBFB-8DE9-588C-DC68DBB5B5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33D45C-063E-F428-2AF1-ECDE69001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44F94C-C113-FCEF-169F-E879B5E31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7E5A07-B4CC-585F-803B-E40B16E66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4641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719171-B4C2-8CBB-D762-3006026C2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2E7289E-B83F-EC9F-7E8A-E511CF9781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9DDC2BC-2A45-C156-6CAA-53D5D95DF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3C255-1FD2-1CD5-3798-69FC5B6E6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9AB5DC-7A5A-F95D-952D-479CF093E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296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0E687B7-E238-6D04-8859-CC46C4718D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1D4A23A-58DC-8675-EDB4-92C78452ED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5B4F72-73AD-1300-CB80-D23E32D81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FC0F3E-4FEB-378E-0907-51B65922B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31B26F-6DA0-0D94-CC5B-6ADFF5938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4544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40E929-F2FD-849D-BD9B-CA01144EDC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10FA4E-FBEB-D584-FF90-2337134020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9E169B-91FF-0843-F0AC-27D54CAC4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91B1A8-C90F-CC90-C5EF-0D18D1C26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3FD9369-A636-36F3-83C1-4105216DE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948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48EAEA-72E0-1F52-835E-1F1F1A21E7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6EE8E8-799D-4045-AADB-EF4584DD3D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E29424-17F5-9F58-4231-F11BBF1F7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B7CFFD-5C2A-12EB-6840-6FD1EFFAA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B23580-4147-4CA3-674B-3A5D6B990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940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B5F573-DF22-DC65-26B1-F1400D96DE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3755EB7-925B-BD74-E31C-6B94F265C9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6EB1CD4-E89B-974D-3981-88883A7A29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F3B694-C9E0-B983-0F18-B7D30261A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EDD517-D481-0D82-A405-A54301525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CC2CA84-1A1C-2B43-55FA-07EA5E2161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456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DC5A6F-FC69-E6DB-32A4-82D41F0E9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20334B1-3178-87AE-121C-4340191CA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154F5D-6AC6-8AE2-E47D-C962DF6058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D3C83DF-35BA-2ED8-1828-4B40ED8DFF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919F093-BC87-54AF-DBB1-FF95BD8CAB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1F5B291-1472-561A-DF55-D7AAF36F3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608119C-E2D7-A373-3182-2F9261942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C81D6B9-EDE8-C78A-03BF-E1A8299192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850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B53A40-4673-27CA-8DCF-D45D0617B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E48B7E7-08C8-3D3B-D774-E61B0306E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A43D080-E353-F0EB-8CC2-D6B9DEE95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FCE531D-14E9-DA24-5EBF-15413FDC4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703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6ECF48E-349A-B7AE-0B84-EF78B55DA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7556882-3F09-28AB-1548-9B8D50B6B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0A1BD4F-BA2F-B79B-D948-447B1EDA3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8688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418B88-FB0C-ABCB-4B2A-3CAB222A4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44D4A2E-54C6-40E7-0137-22BE6F9127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620CEBF-BBFC-4E04-B052-54E5F8753C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93CA7A-49E2-0A7A-FDD0-9DE0461A1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257F3D2-BF7A-4731-8654-F240F3193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FB10CB7-16D2-874B-F35F-EB6DA72F1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9695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0A4D40-4853-A31C-F030-00F5051829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1F89BDD-F5F9-0DAC-115F-4AAB7888C2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ACC8572-816B-84D5-0BCC-A645CC7DD7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1606105-7E10-A317-F023-202B1A5A7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53B65B-A6D4-3AB7-8113-29E358CDEE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642D9FB-37FD-1EB0-77B0-135B6B607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231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4F658F4-0F9D-02A8-D553-5CA90F8CE5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C33197-4B63-D247-7477-BF0B97689E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6C7FF3-7C35-8DAA-EF0F-2AE45B73E6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AC07FA-0431-4685-8946-316E5C8B479C}" type="datetimeFigureOut">
              <a:rPr kumimoji="1" lang="ja-JP" altLang="en-US" smtClean="0"/>
              <a:t>2025/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CBED63-7B72-5D66-3526-57D6220D49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6F7E9A-1CA8-0E75-0314-1415B33C6D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BA52E7-29C6-40DF-A5A4-934A2CB8FD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819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81E6FB2E-57DE-A8AD-DB31-0224379095ED}"/>
              </a:ext>
            </a:extLst>
          </p:cNvPr>
          <p:cNvSpPr txBox="1"/>
          <p:nvPr/>
        </p:nvSpPr>
        <p:spPr>
          <a:xfrm>
            <a:off x="2440097" y="948420"/>
            <a:ext cx="13647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BB0C3F47-0C43-DDBA-E848-0466D9C9B019}"/>
              </a:ext>
            </a:extLst>
          </p:cNvPr>
          <p:cNvSpPr txBox="1"/>
          <p:nvPr/>
        </p:nvSpPr>
        <p:spPr>
          <a:xfrm>
            <a:off x="2442592" y="1178225"/>
            <a:ext cx="1257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935E25B6-C827-BEDD-6A3C-DCC92120030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00810" y="903188"/>
            <a:ext cx="2382931" cy="2225348"/>
            <a:chOff x="1849" y="401"/>
            <a:chExt cx="2979" cy="2782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0225EA92-E35B-65D4-AB88-A00D93D61E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932"/>
              <a:ext cx="62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88EE9E43-A765-6972-B613-B750E8DD4D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932"/>
              <a:ext cx="62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5C519329-0720-2682-C90C-DECE9B8D43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2834"/>
              <a:ext cx="62" cy="98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EE949D2F-9A04-02EC-4C4A-4B69F18AAE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2834"/>
              <a:ext cx="62" cy="9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3A5EB5AE-2F28-241A-35E5-D90DEE6D29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3" y="2932"/>
              <a:ext cx="62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DB89A256-9CB8-E05D-AABE-622CE1929E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3" y="2932"/>
              <a:ext cx="62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9298E5F4-79F5-1A36-5F32-336DB7FCB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" y="2834"/>
              <a:ext cx="62" cy="98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E541CA9A-745E-BA1B-0AB8-3FEA35E809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" y="2834"/>
              <a:ext cx="62" cy="9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785A0C67-57D1-4AE9-8EA3-47356ECCB2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2" y="2880"/>
              <a:ext cx="6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7ADB3756-F647-4385-E7B7-F2EF0AC08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2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244727AC-1E83-E108-F40C-220FD71786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" y="2541"/>
              <a:ext cx="62" cy="39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8D7F69CD-602B-C304-29AC-D337DA2F32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" y="2541"/>
              <a:ext cx="62" cy="39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7D3465CD-5660-710D-27DE-5FDA962077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" y="2880"/>
              <a:ext cx="61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FC0C6BB8-B2E0-2867-C816-A9CD552165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" y="2880"/>
              <a:ext cx="61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4028F8D8-84E6-9051-9C28-F9640994C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3" y="2782"/>
              <a:ext cx="62" cy="15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2EAE7A84-2186-1872-A2DC-67908FD48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3" y="2782"/>
              <a:ext cx="62" cy="15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AEA18A5D-7338-3DA6-B302-39C6ED14BB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1" y="2932"/>
              <a:ext cx="61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8199B6B9-FE4E-6292-7950-F4CEA10DC1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1" y="2932"/>
              <a:ext cx="61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E211EB4B-BB4D-6F96-0894-8E92A1A6D2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" y="2299"/>
              <a:ext cx="62" cy="63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D53B1563-6D9D-1325-1966-48228BAA8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" y="2299"/>
              <a:ext cx="62" cy="63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AAAE49EB-26F9-A167-9353-89EE277806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2880"/>
              <a:ext cx="6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5E8C3E21-E301-C969-20B2-1A66ABB522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D92A507B-FBC8-A5B4-88C7-ABC338D6B4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" y="2299"/>
              <a:ext cx="61" cy="63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7BC0F2C8-38B3-C778-54C5-6278326546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2" y="2299"/>
              <a:ext cx="61" cy="63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9724A936-BE4A-99C2-96FF-1963C9EB8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" y="2638"/>
              <a:ext cx="62" cy="29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10DE9FAC-BC5E-E2D5-E9C1-494162F5A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" y="2638"/>
              <a:ext cx="62" cy="29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035DC541-5034-24F3-BD77-DC0C0DBE6A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6" y="1862"/>
              <a:ext cx="61" cy="107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8B63AA75-05E2-BCA9-8897-0FC312666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6" y="1862"/>
              <a:ext cx="61" cy="107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52E0BED6-D105-BE2A-38A0-9B6BBD90C8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3" y="2397"/>
              <a:ext cx="62" cy="535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73F30DDE-1FF9-4450-8587-8AFEFFCAD9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3" y="2397"/>
              <a:ext cx="62" cy="53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4658AAA4-21CC-6FC2-F0AE-463F460A92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" y="1569"/>
              <a:ext cx="61" cy="136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E1B95B0C-D4D1-07FE-2E8A-5300368016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" y="1569"/>
              <a:ext cx="61" cy="136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421E769E-66A6-9905-41B9-103CC355C7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2" y="2104"/>
              <a:ext cx="62" cy="828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A82D6386-6BD3-E59D-2C1C-AD66D2CD6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2" y="2104"/>
              <a:ext cx="62" cy="82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523CF1C4-FF34-8ED2-51D7-8CF168072B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4" y="1085"/>
              <a:ext cx="62" cy="18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E133C1B0-82C1-5012-2613-D2AFEDA4BD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4" y="1085"/>
              <a:ext cx="62" cy="18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E6C7232E-85B9-27BA-1AFE-7DF2B9A912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1" y="1810"/>
              <a:ext cx="62" cy="112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2F31DDF2-6188-BA42-094E-32E5FAB7DB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1" y="1810"/>
              <a:ext cx="62" cy="112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05EFD391-90FC-0ED8-A66B-F2B38A9B0B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3" y="401"/>
              <a:ext cx="62" cy="253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6ACAF601-BEE2-B3D2-DC9D-BE1AFEA912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3" y="401"/>
              <a:ext cx="62" cy="253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BC774633-E2A8-7FA2-FA12-56C7ABC55D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5" y="2006"/>
              <a:ext cx="62" cy="926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C399A4F7-23DC-D666-003A-370EB07947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5" y="2006"/>
              <a:ext cx="62" cy="92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FEA0A43C-24A9-0E39-EC6A-DB881B517D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7" y="1522"/>
              <a:ext cx="62" cy="141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E9D83762-986E-9861-8EA9-B41818AACA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7" y="1522"/>
              <a:ext cx="62" cy="141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4643310D-75F7-E298-9956-95941C05F4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4" y="2299"/>
              <a:ext cx="62" cy="633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A5669C67-A366-E6B4-6285-580544EB15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4" y="2299"/>
              <a:ext cx="62" cy="63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B6AC84E1-0881-0CEA-97EF-30212A2DD5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6" y="2006"/>
              <a:ext cx="62" cy="926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C67CAFCB-A30D-8C9A-4F1C-56179367F0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6" y="2006"/>
              <a:ext cx="62" cy="92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8C849600-2FB8-B27F-2CCA-43383F17FA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685"/>
              <a:ext cx="61" cy="2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C5C766CD-30BE-0F38-1AF6-240AECD590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4" y="2685"/>
              <a:ext cx="61" cy="2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4690C01F-F35D-E6EA-0DA9-8A03C59D76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5" y="2638"/>
              <a:ext cx="62" cy="294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0E394A85-28F2-6834-D671-7A5783657F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5" y="2638"/>
              <a:ext cx="62" cy="29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C23C85FF-C3D4-37D8-D1A8-AA2E24078F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3" y="2685"/>
              <a:ext cx="61" cy="2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0BF7878C-9724-52A1-74DE-782864E31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3" y="2685"/>
              <a:ext cx="61" cy="2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29521DCA-37F1-D0B9-3BD9-C044E34390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4" y="2782"/>
              <a:ext cx="62" cy="15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DDDCA373-7E6F-6B0C-17B2-DBFA3C22C2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4" y="2782"/>
              <a:ext cx="62" cy="15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0EDEC4F9-7FA8-6F03-E650-41A501051D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7" y="2880"/>
              <a:ext cx="61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7C8A6ADB-7A57-CBDD-30F1-2BB8801F63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7" y="2880"/>
              <a:ext cx="61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101B5C98-0C3A-64F7-9765-04887D0C8D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8" y="2880"/>
              <a:ext cx="62" cy="5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08CC9FF6-9244-4B17-6A90-10C1545CCC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8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3A29B397-5D71-0C57-535F-77F907427B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6" y="2880"/>
              <a:ext cx="6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A7D7D7AD-113E-B1ED-6323-5124343364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6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0CE8C325-793A-A113-01FA-61D35BAE8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8" y="2932"/>
              <a:ext cx="61" cy="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602B4E18-1C8C-D574-AF42-AC910E5CEA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8" y="2932"/>
              <a:ext cx="61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DE442FFE-6C20-1650-9651-2C958F4967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5" y="2880"/>
              <a:ext cx="6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BD19876F-2A3E-16D8-1112-38AB63F2A9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5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BE3065A2-DF62-EDB7-6F0D-231CB0278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7" y="2880"/>
              <a:ext cx="62" cy="5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6C32B290-AA05-DD90-1871-33F9DCB733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7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87F3F18C-1C3D-A688-0264-E7CA97F9CF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4" y="2880"/>
              <a:ext cx="6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B99DDA87-9445-E503-B58C-57DD394A31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4" y="2880"/>
              <a:ext cx="6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8B5D5BBE-015E-316E-3381-743012320A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6" y="2932"/>
              <a:ext cx="62" cy="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F9AE6550-5D14-E45C-6A2F-79357D9BF2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6" y="2932"/>
              <a:ext cx="62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Line 77">
              <a:extLst>
                <a:ext uri="{FF2B5EF4-FFF2-40B4-BE49-F238E27FC236}">
                  <a16:creationId xmlns:a16="http://schemas.microsoft.com/office/drawing/2014/main" id="{939A9507-212F-46FE-D935-43CDB24886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1" y="2957"/>
              <a:ext cx="251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Line 78">
              <a:extLst>
                <a:ext uri="{FF2B5EF4-FFF2-40B4-BE49-F238E27FC236}">
                  <a16:creationId xmlns:a16="http://schemas.microsoft.com/office/drawing/2014/main" id="{B4174D1A-A742-A678-064D-3AAAA1A5E7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" name="Line 79">
              <a:extLst>
                <a:ext uri="{FF2B5EF4-FFF2-40B4-BE49-F238E27FC236}">
                  <a16:creationId xmlns:a16="http://schemas.microsoft.com/office/drawing/2014/main" id="{DFE4677D-0757-CE44-8551-55260575BB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5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3" name="Line 80">
              <a:extLst>
                <a:ext uri="{FF2B5EF4-FFF2-40B4-BE49-F238E27FC236}">
                  <a16:creationId xmlns:a16="http://schemas.microsoft.com/office/drawing/2014/main" id="{5645FAA3-76EF-697F-52D4-4217BC155C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4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4" name="Line 81">
              <a:extLst>
                <a:ext uri="{FF2B5EF4-FFF2-40B4-BE49-F238E27FC236}">
                  <a16:creationId xmlns:a16="http://schemas.microsoft.com/office/drawing/2014/main" id="{9DBD5ED7-9482-8BF6-F13A-498AD27C94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3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id="{D4A051A8-2289-16C3-FA8C-978848A1AA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2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6" name="Line 83">
              <a:extLst>
                <a:ext uri="{FF2B5EF4-FFF2-40B4-BE49-F238E27FC236}">
                  <a16:creationId xmlns:a16="http://schemas.microsoft.com/office/drawing/2014/main" id="{5FC818A9-AC83-4A0F-7286-9D2545AC33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2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7" name="Line 84">
              <a:extLst>
                <a:ext uri="{FF2B5EF4-FFF2-40B4-BE49-F238E27FC236}">
                  <a16:creationId xmlns:a16="http://schemas.microsoft.com/office/drawing/2014/main" id="{BCA1BEBB-A3D3-4667-771C-B05359F105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8" name="Line 85">
              <a:extLst>
                <a:ext uri="{FF2B5EF4-FFF2-40B4-BE49-F238E27FC236}">
                  <a16:creationId xmlns:a16="http://schemas.microsoft.com/office/drawing/2014/main" id="{E627AC28-E018-9DB8-B692-EC303EBAAA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5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Line 86">
              <a:extLst>
                <a:ext uri="{FF2B5EF4-FFF2-40B4-BE49-F238E27FC236}">
                  <a16:creationId xmlns:a16="http://schemas.microsoft.com/office/drawing/2014/main" id="{B1B9B218-F243-7309-77E0-161CEB9338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4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Line 87">
              <a:extLst>
                <a:ext uri="{FF2B5EF4-FFF2-40B4-BE49-F238E27FC236}">
                  <a16:creationId xmlns:a16="http://schemas.microsoft.com/office/drawing/2014/main" id="{5D5073DD-3815-DAD0-B3D4-6E1265308D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3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Line 88">
              <a:extLst>
                <a:ext uri="{FF2B5EF4-FFF2-40B4-BE49-F238E27FC236}">
                  <a16:creationId xmlns:a16="http://schemas.microsoft.com/office/drawing/2014/main" id="{B1ACDEFB-E757-97BB-FD85-200D285D34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7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Line 89">
              <a:extLst>
                <a:ext uri="{FF2B5EF4-FFF2-40B4-BE49-F238E27FC236}">
                  <a16:creationId xmlns:a16="http://schemas.microsoft.com/office/drawing/2014/main" id="{9DDF5811-F4A5-0E0B-57E5-B78D9C5289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Line 90">
              <a:extLst>
                <a:ext uri="{FF2B5EF4-FFF2-40B4-BE49-F238E27FC236}">
                  <a16:creationId xmlns:a16="http://schemas.microsoft.com/office/drawing/2014/main" id="{06BEF1A1-A5C4-3842-4130-5C0B83B1D7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5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" name="Line 91">
              <a:extLst>
                <a:ext uri="{FF2B5EF4-FFF2-40B4-BE49-F238E27FC236}">
                  <a16:creationId xmlns:a16="http://schemas.microsoft.com/office/drawing/2014/main" id="{93D4516B-2A60-8E09-5A08-9B8CF5DF59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4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Line 92">
              <a:extLst>
                <a:ext uri="{FF2B5EF4-FFF2-40B4-BE49-F238E27FC236}">
                  <a16:creationId xmlns:a16="http://schemas.microsoft.com/office/drawing/2014/main" id="{663E1963-86BE-29B8-7D74-716A1F887D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18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Line 93">
              <a:extLst>
                <a:ext uri="{FF2B5EF4-FFF2-40B4-BE49-F238E27FC236}">
                  <a16:creationId xmlns:a16="http://schemas.microsoft.com/office/drawing/2014/main" id="{D2E3A1D3-AAD0-2B99-243C-361652B762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68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id="{884A3338-8023-F786-56AB-AAE58A8331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7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Line 95">
              <a:extLst>
                <a:ext uri="{FF2B5EF4-FFF2-40B4-BE49-F238E27FC236}">
                  <a16:creationId xmlns:a16="http://schemas.microsoft.com/office/drawing/2014/main" id="{1FEA4CEA-6B26-79B4-913D-F1E0EC0FDC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6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Rectangle 96">
              <a:extLst>
                <a:ext uri="{FF2B5EF4-FFF2-40B4-BE49-F238E27FC236}">
                  <a16:creationId xmlns:a16="http://schemas.microsoft.com/office/drawing/2014/main" id="{9CB0E649-5AD5-C761-D996-70EBD7F2B8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2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9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C3A5E60C-B98D-93F8-42BA-8A1E7F0004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5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7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98">
              <a:extLst>
                <a:ext uri="{FF2B5EF4-FFF2-40B4-BE49-F238E27FC236}">
                  <a16:creationId xmlns:a16="http://schemas.microsoft.com/office/drawing/2014/main" id="{CD03FC87-379C-1DEE-1837-D134546563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3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5AF2F08E-CC86-49D5-309E-AFFFB185AE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7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0">
              <a:extLst>
                <a:ext uri="{FF2B5EF4-FFF2-40B4-BE49-F238E27FC236}">
                  <a16:creationId xmlns:a16="http://schemas.microsoft.com/office/drawing/2014/main" id="{66F6BB3E-7B32-3F72-C62D-FE6469465D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5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01">
              <a:extLst>
                <a:ext uri="{FF2B5EF4-FFF2-40B4-BE49-F238E27FC236}">
                  <a16:creationId xmlns:a16="http://schemas.microsoft.com/office/drawing/2014/main" id="{2B2E3C4B-304E-1E08-5C1A-B83EF2FBCC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0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102">
              <a:extLst>
                <a:ext uri="{FF2B5EF4-FFF2-40B4-BE49-F238E27FC236}">
                  <a16:creationId xmlns:a16="http://schemas.microsoft.com/office/drawing/2014/main" id="{530DCEAE-8A7E-08F3-A3EC-D97E328C63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8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103">
              <a:extLst>
                <a:ext uri="{FF2B5EF4-FFF2-40B4-BE49-F238E27FC236}">
                  <a16:creationId xmlns:a16="http://schemas.microsoft.com/office/drawing/2014/main" id="{22979B73-EBC2-5E09-2F5B-EEF9F8187E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1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1CCFDC96-269C-D58B-0A35-D225368CA9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5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5">
              <a:extLst>
                <a:ext uri="{FF2B5EF4-FFF2-40B4-BE49-F238E27FC236}">
                  <a16:creationId xmlns:a16="http://schemas.microsoft.com/office/drawing/2014/main" id="{8692A9BD-0A59-1065-598B-03E9566887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9" y="627"/>
              <a:ext cx="62" cy="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109" name="Rectangle 106">
              <a:extLst>
                <a:ext uri="{FF2B5EF4-FFF2-40B4-BE49-F238E27FC236}">
                  <a16:creationId xmlns:a16="http://schemas.microsoft.com/office/drawing/2014/main" id="{DE202406-EF77-0025-E23B-101CD8B976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8" y="628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Rectangle 107">
              <a:extLst>
                <a:ext uri="{FF2B5EF4-FFF2-40B4-BE49-F238E27FC236}">
                  <a16:creationId xmlns:a16="http://schemas.microsoft.com/office/drawing/2014/main" id="{591480DD-E877-9967-B698-54D939174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7" y="919"/>
              <a:ext cx="62" cy="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Rectangle 108">
              <a:extLst>
                <a:ext uri="{FF2B5EF4-FFF2-40B4-BE49-F238E27FC236}">
                  <a16:creationId xmlns:a16="http://schemas.microsoft.com/office/drawing/2014/main" id="{57807210-4EA9-C8B4-97A0-762F0A61F6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1" y="917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Line 112">
              <a:extLst>
                <a:ext uri="{FF2B5EF4-FFF2-40B4-BE49-F238E27FC236}">
                  <a16:creationId xmlns:a16="http://schemas.microsoft.com/office/drawing/2014/main" id="{4F907568-14C7-81A8-C7EC-2B55586CA7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1" y="499"/>
              <a:ext cx="0" cy="243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Line 113">
              <a:extLst>
                <a:ext uri="{FF2B5EF4-FFF2-40B4-BE49-F238E27FC236}">
                  <a16:creationId xmlns:a16="http://schemas.microsoft.com/office/drawing/2014/main" id="{464C341B-0A9E-613D-B40E-B49D15970E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93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Line 114">
              <a:extLst>
                <a:ext uri="{FF2B5EF4-FFF2-40B4-BE49-F238E27FC236}">
                  <a16:creationId xmlns:a16="http://schemas.microsoft.com/office/drawing/2014/main" id="{94498768-EEF4-8D48-F3AC-B3290497F4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443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Line 115">
              <a:extLst>
                <a:ext uri="{FF2B5EF4-FFF2-40B4-BE49-F238E27FC236}">
                  <a16:creationId xmlns:a16="http://schemas.microsoft.com/office/drawing/2014/main" id="{CDC1212E-BE11-1EC7-4D37-0E5477AC12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960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Line 116">
              <a:extLst>
                <a:ext uri="{FF2B5EF4-FFF2-40B4-BE49-F238E27FC236}">
                  <a16:creationId xmlns:a16="http://schemas.microsoft.com/office/drawing/2014/main" id="{1AF6F7FC-B2B5-3F4D-1991-7D8A8E2298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471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Line 117">
              <a:extLst>
                <a:ext uri="{FF2B5EF4-FFF2-40B4-BE49-F238E27FC236}">
                  <a16:creationId xmlns:a16="http://schemas.microsoft.com/office/drawing/2014/main" id="{4867DF01-5845-EC98-A0E5-873440F812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988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Line 118">
              <a:extLst>
                <a:ext uri="{FF2B5EF4-FFF2-40B4-BE49-F238E27FC236}">
                  <a16:creationId xmlns:a16="http://schemas.microsoft.com/office/drawing/2014/main" id="{1D2AC0C5-FD45-F5F7-9C9F-6C4D23443A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499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Rectangle 119">
              <a:extLst>
                <a:ext uri="{FF2B5EF4-FFF2-40B4-BE49-F238E27FC236}">
                  <a16:creationId xmlns:a16="http://schemas.microsoft.com/office/drawing/2014/main" id="{8D9DF81A-CEFE-45E1-007D-E020644FDF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" y="2896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120">
              <a:extLst>
                <a:ext uri="{FF2B5EF4-FFF2-40B4-BE49-F238E27FC236}">
                  <a16:creationId xmlns:a16="http://schemas.microsoft.com/office/drawing/2014/main" id="{4CF375F9-90EF-9247-54A4-C5C6B84178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2412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C4832560-AEF1-BF1C-CFC8-4C35398525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924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122">
              <a:extLst>
                <a:ext uri="{FF2B5EF4-FFF2-40B4-BE49-F238E27FC236}">
                  <a16:creationId xmlns:a16="http://schemas.microsoft.com/office/drawing/2014/main" id="{DE1F3416-9110-CB20-A7DB-EC9BCA4764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440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Rectangle 123">
              <a:extLst>
                <a:ext uri="{FF2B5EF4-FFF2-40B4-BE49-F238E27FC236}">
                  <a16:creationId xmlns:a16="http://schemas.microsoft.com/office/drawing/2014/main" id="{86FFFDA3-9DD6-3CAE-6EDC-A9B60D526E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952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Rectangle 124">
              <a:extLst>
                <a:ext uri="{FF2B5EF4-FFF2-40B4-BE49-F238E27FC236}">
                  <a16:creationId xmlns:a16="http://schemas.microsoft.com/office/drawing/2014/main" id="{ECA7FE83-6856-DC95-B50E-9D01B4A23A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468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9BC404DD-E478-DA6E-DF73-4EA4656DB1FE}"/>
              </a:ext>
            </a:extLst>
          </p:cNvPr>
          <p:cNvSpPr txBox="1"/>
          <p:nvPr/>
        </p:nvSpPr>
        <p:spPr>
          <a:xfrm>
            <a:off x="109830" y="94489"/>
            <a:ext cx="3908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46CC912F-7802-1F52-C98E-4EC970C9E797}"/>
              </a:ext>
            </a:extLst>
          </p:cNvPr>
          <p:cNvSpPr txBox="1"/>
          <p:nvPr/>
        </p:nvSpPr>
        <p:spPr>
          <a:xfrm>
            <a:off x="896400" y="468492"/>
            <a:ext cx="26538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VFA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a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0.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5956DEFC-B60D-A54F-D472-A0BCFB2E910B}"/>
              </a:ext>
            </a:extLst>
          </p:cNvPr>
          <p:cNvSpPr txBox="1"/>
          <p:nvPr/>
        </p:nvSpPr>
        <p:spPr>
          <a:xfrm>
            <a:off x="4731011" y="466867"/>
            <a:ext cx="26538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VFA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a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Rectangle 104">
            <a:extLst>
              <a:ext uri="{FF2B5EF4-FFF2-40B4-BE49-F238E27FC236}">
                <a16:creationId xmlns:a16="http://schemas.microsoft.com/office/drawing/2014/main" id="{3CA9E461-F6D0-9D86-5DFE-DD7CDCEE52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6115" y="3035298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dirty="0">
                <a:solidFill>
                  <a:srgbClr val="000000"/>
                </a:solidFill>
              </a:rPr>
              <a:t>8</a:t>
            </a: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r>
              <a:rPr kumimoji="0" lang="ja-JP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≤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37" name="Group 127">
            <a:extLst>
              <a:ext uri="{FF2B5EF4-FFF2-40B4-BE49-F238E27FC236}">
                <a16:creationId xmlns:a16="http://schemas.microsoft.com/office/drawing/2014/main" id="{A2A5E942-457B-7848-DCFD-59F79FA7BC6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574155" y="807808"/>
            <a:ext cx="2454476" cy="2306214"/>
            <a:chOff x="1849" y="401"/>
            <a:chExt cx="3013" cy="2831"/>
          </a:xfrm>
        </p:grpSpPr>
        <p:sp>
          <p:nvSpPr>
            <p:cNvPr id="139" name="Rectangle 128">
              <a:extLst>
                <a:ext uri="{FF2B5EF4-FFF2-40B4-BE49-F238E27FC236}">
                  <a16:creationId xmlns:a16="http://schemas.microsoft.com/office/drawing/2014/main" id="{7D9D6D81-C650-C889-CC23-96CA8B178F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932"/>
              <a:ext cx="124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Rectangle 129">
              <a:extLst>
                <a:ext uri="{FF2B5EF4-FFF2-40B4-BE49-F238E27FC236}">
                  <a16:creationId xmlns:a16="http://schemas.microsoft.com/office/drawing/2014/main" id="{C020C10D-C431-80F4-D811-8AD5482FA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932"/>
              <a:ext cx="124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Rectangle 130">
              <a:extLst>
                <a:ext uri="{FF2B5EF4-FFF2-40B4-BE49-F238E27FC236}">
                  <a16:creationId xmlns:a16="http://schemas.microsoft.com/office/drawing/2014/main" id="{D1C7B8B3-09DB-9B0A-9FDF-E28D51A9C2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3" y="2731"/>
              <a:ext cx="123" cy="20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Rectangle 131">
              <a:extLst>
                <a:ext uri="{FF2B5EF4-FFF2-40B4-BE49-F238E27FC236}">
                  <a16:creationId xmlns:a16="http://schemas.microsoft.com/office/drawing/2014/main" id="{089D9B48-C478-DE8A-BEB3-DA85C90A0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3" y="2731"/>
              <a:ext cx="123" cy="20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Rectangle 132">
              <a:extLst>
                <a:ext uri="{FF2B5EF4-FFF2-40B4-BE49-F238E27FC236}">
                  <a16:creationId xmlns:a16="http://schemas.microsoft.com/office/drawing/2014/main" id="{07FEC4D4-3555-B458-8FD7-2EF861EEE1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8" y="2896"/>
              <a:ext cx="123" cy="36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Rectangle 133">
              <a:extLst>
                <a:ext uri="{FF2B5EF4-FFF2-40B4-BE49-F238E27FC236}">
                  <a16:creationId xmlns:a16="http://schemas.microsoft.com/office/drawing/2014/main" id="{A0491B20-2157-9886-1174-7EF738EF18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8" y="2896"/>
              <a:ext cx="123" cy="3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Rectangle 134">
              <a:extLst>
                <a:ext uri="{FF2B5EF4-FFF2-40B4-BE49-F238E27FC236}">
                  <a16:creationId xmlns:a16="http://schemas.microsoft.com/office/drawing/2014/main" id="{C7F4BCDB-8E56-2640-A116-5225477B66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1" y="2505"/>
              <a:ext cx="123" cy="42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Rectangle 135">
              <a:extLst>
                <a:ext uri="{FF2B5EF4-FFF2-40B4-BE49-F238E27FC236}">
                  <a16:creationId xmlns:a16="http://schemas.microsoft.com/office/drawing/2014/main" id="{2715AF97-F22C-D49E-523E-B363FB5E3A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1" y="2505"/>
              <a:ext cx="123" cy="42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Rectangle 136">
              <a:extLst>
                <a:ext uri="{FF2B5EF4-FFF2-40B4-BE49-F238E27FC236}">
                  <a16:creationId xmlns:a16="http://schemas.microsoft.com/office/drawing/2014/main" id="{B9A3F9B3-A39E-D9BC-D605-0D80AE9946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" y="2834"/>
              <a:ext cx="123" cy="98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Rectangle 137">
              <a:extLst>
                <a:ext uri="{FF2B5EF4-FFF2-40B4-BE49-F238E27FC236}">
                  <a16:creationId xmlns:a16="http://schemas.microsoft.com/office/drawing/2014/main" id="{B8EF0D24-51F0-6515-0524-495547EC5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" y="2834"/>
              <a:ext cx="123" cy="9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Rectangle 138">
              <a:extLst>
                <a:ext uri="{FF2B5EF4-FFF2-40B4-BE49-F238E27FC236}">
                  <a16:creationId xmlns:a16="http://schemas.microsoft.com/office/drawing/2014/main" id="{E96C5403-68CF-4CB8-87A6-FFBE6FCCAE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" y="2304"/>
              <a:ext cx="124" cy="628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Rectangle 139">
              <a:extLst>
                <a:ext uri="{FF2B5EF4-FFF2-40B4-BE49-F238E27FC236}">
                  <a16:creationId xmlns:a16="http://schemas.microsoft.com/office/drawing/2014/main" id="{0D68245B-43F6-5D89-3D16-DF2984D631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" y="2304"/>
              <a:ext cx="124" cy="62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Rectangle 140">
              <a:extLst>
                <a:ext uri="{FF2B5EF4-FFF2-40B4-BE49-F238E27FC236}">
                  <a16:creationId xmlns:a16="http://schemas.microsoft.com/office/drawing/2014/main" id="{CE6D1134-397B-6DD1-2DD9-9674F838E8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4" y="2566"/>
              <a:ext cx="124" cy="366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Rectangle 141">
              <a:extLst>
                <a:ext uri="{FF2B5EF4-FFF2-40B4-BE49-F238E27FC236}">
                  <a16:creationId xmlns:a16="http://schemas.microsoft.com/office/drawing/2014/main" id="{E58B7671-FBAA-4D86-3151-5D180D7878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4" y="2566"/>
              <a:ext cx="124" cy="36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Rectangle 142">
              <a:extLst>
                <a:ext uri="{FF2B5EF4-FFF2-40B4-BE49-F238E27FC236}">
                  <a16:creationId xmlns:a16="http://schemas.microsoft.com/office/drawing/2014/main" id="{4B474863-9B4C-C17B-6994-0698F9C33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8" y="1877"/>
              <a:ext cx="123" cy="1055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Rectangle 143">
              <a:extLst>
                <a:ext uri="{FF2B5EF4-FFF2-40B4-BE49-F238E27FC236}">
                  <a16:creationId xmlns:a16="http://schemas.microsoft.com/office/drawing/2014/main" id="{D3C5EA76-E613-654B-7F4C-8D66837CD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8" y="1877"/>
              <a:ext cx="123" cy="105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Rectangle 144">
              <a:extLst>
                <a:ext uri="{FF2B5EF4-FFF2-40B4-BE49-F238E27FC236}">
                  <a16:creationId xmlns:a16="http://schemas.microsoft.com/office/drawing/2014/main" id="{392103FD-E3CB-27EF-C76D-A28E7DA06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2" y="2176"/>
              <a:ext cx="124" cy="756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Rectangle 145">
              <a:extLst>
                <a:ext uri="{FF2B5EF4-FFF2-40B4-BE49-F238E27FC236}">
                  <a16:creationId xmlns:a16="http://schemas.microsoft.com/office/drawing/2014/main" id="{BF3F33AC-2BBF-5168-6BCB-70C6F2BFA2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2" y="2176"/>
              <a:ext cx="124" cy="75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Rectangle 146">
              <a:extLst>
                <a:ext uri="{FF2B5EF4-FFF2-40B4-BE49-F238E27FC236}">
                  <a16:creationId xmlns:a16="http://schemas.microsoft.com/office/drawing/2014/main" id="{F3AA91C7-3BE5-886E-F60E-5CDDF23ECE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401"/>
              <a:ext cx="123" cy="253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Rectangle 147">
              <a:extLst>
                <a:ext uri="{FF2B5EF4-FFF2-40B4-BE49-F238E27FC236}">
                  <a16:creationId xmlns:a16="http://schemas.microsoft.com/office/drawing/2014/main" id="{230EEC8C-9A27-1483-2C9E-A38890F6DB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401"/>
              <a:ext cx="123" cy="253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Rectangle 148">
              <a:extLst>
                <a:ext uri="{FF2B5EF4-FFF2-40B4-BE49-F238E27FC236}">
                  <a16:creationId xmlns:a16="http://schemas.microsoft.com/office/drawing/2014/main" id="{4B380513-6618-1B3B-D659-D293C4B62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1" y="1780"/>
              <a:ext cx="123" cy="11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Rectangle 149">
              <a:extLst>
                <a:ext uri="{FF2B5EF4-FFF2-40B4-BE49-F238E27FC236}">
                  <a16:creationId xmlns:a16="http://schemas.microsoft.com/office/drawing/2014/main" id="{03CAB55C-2A8D-E69B-DAEA-AC8F2C61EB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1" y="1780"/>
              <a:ext cx="123" cy="11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Rectangle 150">
              <a:extLst>
                <a:ext uri="{FF2B5EF4-FFF2-40B4-BE49-F238E27FC236}">
                  <a16:creationId xmlns:a16="http://schemas.microsoft.com/office/drawing/2014/main" id="{0A005E0D-23AE-F564-7A34-C7EE000F8E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" y="1060"/>
              <a:ext cx="124" cy="187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Rectangle 151">
              <a:extLst>
                <a:ext uri="{FF2B5EF4-FFF2-40B4-BE49-F238E27FC236}">
                  <a16:creationId xmlns:a16="http://schemas.microsoft.com/office/drawing/2014/main" id="{43E6D536-99A2-BE28-3A99-DC13F19A6D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" y="1060"/>
              <a:ext cx="124" cy="187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" name="Rectangle 152">
              <a:extLst>
                <a:ext uri="{FF2B5EF4-FFF2-40B4-BE49-F238E27FC236}">
                  <a16:creationId xmlns:a16="http://schemas.microsoft.com/office/drawing/2014/main" id="{E45DEBB8-3B5C-207A-78B6-C1A357DE4E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2304"/>
              <a:ext cx="123" cy="628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4" name="Rectangle 153">
              <a:extLst>
                <a:ext uri="{FF2B5EF4-FFF2-40B4-BE49-F238E27FC236}">
                  <a16:creationId xmlns:a16="http://schemas.microsoft.com/office/drawing/2014/main" id="{A4309CA5-CDE2-523D-37BF-F717C66822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2304"/>
              <a:ext cx="123" cy="62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Rectangle 154">
              <a:extLst>
                <a:ext uri="{FF2B5EF4-FFF2-40B4-BE49-F238E27FC236}">
                  <a16:creationId xmlns:a16="http://schemas.microsoft.com/office/drawing/2014/main" id="{57E42A8F-DF15-C138-8D98-20FB58213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2" y="2242"/>
              <a:ext cx="129" cy="69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Rectangle 155">
              <a:extLst>
                <a:ext uri="{FF2B5EF4-FFF2-40B4-BE49-F238E27FC236}">
                  <a16:creationId xmlns:a16="http://schemas.microsoft.com/office/drawing/2014/main" id="{642FCFFF-A49F-E092-6DB3-EFD0FE3E22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2" y="2242"/>
              <a:ext cx="129" cy="69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Rectangle 156">
              <a:extLst>
                <a:ext uri="{FF2B5EF4-FFF2-40B4-BE49-F238E27FC236}">
                  <a16:creationId xmlns:a16="http://schemas.microsoft.com/office/drawing/2014/main" id="{2D35B8B1-77A7-F37E-FD0E-AD910B5A2B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7" y="2633"/>
              <a:ext cx="124" cy="299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Rectangle 157">
              <a:extLst>
                <a:ext uri="{FF2B5EF4-FFF2-40B4-BE49-F238E27FC236}">
                  <a16:creationId xmlns:a16="http://schemas.microsoft.com/office/drawing/2014/main" id="{B7945641-09A7-E085-2F93-289C0F1879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7" y="2633"/>
              <a:ext cx="124" cy="29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Rectangle 158">
              <a:extLst>
                <a:ext uri="{FF2B5EF4-FFF2-40B4-BE49-F238E27FC236}">
                  <a16:creationId xmlns:a16="http://schemas.microsoft.com/office/drawing/2014/main" id="{17C97E53-25BB-5F9B-2AFA-169B253397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1" y="2700"/>
              <a:ext cx="128" cy="23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Rectangle 159">
              <a:extLst>
                <a:ext uri="{FF2B5EF4-FFF2-40B4-BE49-F238E27FC236}">
                  <a16:creationId xmlns:a16="http://schemas.microsoft.com/office/drawing/2014/main" id="{806665D2-E586-0E03-F197-1AD7467167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1" y="2700"/>
              <a:ext cx="128" cy="23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Rectangle 160">
              <a:extLst>
                <a:ext uri="{FF2B5EF4-FFF2-40B4-BE49-F238E27FC236}">
                  <a16:creationId xmlns:a16="http://schemas.microsoft.com/office/drawing/2014/main" id="{B824B73E-E772-7FF4-2E07-6AE07241B8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6" y="2767"/>
              <a:ext cx="123" cy="165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Rectangle 161">
              <a:extLst>
                <a:ext uri="{FF2B5EF4-FFF2-40B4-BE49-F238E27FC236}">
                  <a16:creationId xmlns:a16="http://schemas.microsoft.com/office/drawing/2014/main" id="{40DE1CAB-C2F6-F957-7E6D-4473805334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6" y="2767"/>
              <a:ext cx="123" cy="16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Rectangle 162">
              <a:extLst>
                <a:ext uri="{FF2B5EF4-FFF2-40B4-BE49-F238E27FC236}">
                  <a16:creationId xmlns:a16="http://schemas.microsoft.com/office/drawing/2014/main" id="{D75E07BF-DB8B-33AD-9497-58C06A906C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9" y="2669"/>
              <a:ext cx="129" cy="26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Rectangle 163">
              <a:extLst>
                <a:ext uri="{FF2B5EF4-FFF2-40B4-BE49-F238E27FC236}">
                  <a16:creationId xmlns:a16="http://schemas.microsoft.com/office/drawing/2014/main" id="{5652BDD2-F7B2-B5E2-864E-8400F09F9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9" y="2669"/>
              <a:ext cx="129" cy="26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Line 164">
              <a:extLst>
                <a:ext uri="{FF2B5EF4-FFF2-40B4-BE49-F238E27FC236}">
                  <a16:creationId xmlns:a16="http://schemas.microsoft.com/office/drawing/2014/main" id="{E291D2A3-D985-480C-521D-3CEBDB84C0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3" y="2957"/>
              <a:ext cx="238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Line 165">
              <a:extLst>
                <a:ext uri="{FF2B5EF4-FFF2-40B4-BE49-F238E27FC236}">
                  <a16:creationId xmlns:a16="http://schemas.microsoft.com/office/drawing/2014/main" id="{881E38E2-4D5B-27E3-D14E-4442466859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3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Line 166">
              <a:extLst>
                <a:ext uri="{FF2B5EF4-FFF2-40B4-BE49-F238E27FC236}">
                  <a16:creationId xmlns:a16="http://schemas.microsoft.com/office/drawing/2014/main" id="{3390AD88-0316-84F5-496F-89D75C1914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Line 167">
              <a:extLst>
                <a:ext uri="{FF2B5EF4-FFF2-40B4-BE49-F238E27FC236}">
                  <a16:creationId xmlns:a16="http://schemas.microsoft.com/office/drawing/2014/main" id="{DFCDDB22-6306-16BE-B593-10E200204D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9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9" name="Line 168">
              <a:extLst>
                <a:ext uri="{FF2B5EF4-FFF2-40B4-BE49-F238E27FC236}">
                  <a16:creationId xmlns:a16="http://schemas.microsoft.com/office/drawing/2014/main" id="{3A0F6ABE-DE17-4812-7202-B59DD3AE3B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8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Line 169">
              <a:extLst>
                <a:ext uri="{FF2B5EF4-FFF2-40B4-BE49-F238E27FC236}">
                  <a16:creationId xmlns:a16="http://schemas.microsoft.com/office/drawing/2014/main" id="{E7BE13DE-F170-05AB-F6E4-9E78FDAB3C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Line 170">
              <a:extLst>
                <a:ext uri="{FF2B5EF4-FFF2-40B4-BE49-F238E27FC236}">
                  <a16:creationId xmlns:a16="http://schemas.microsoft.com/office/drawing/2014/main" id="{7E9EBF21-CF9B-891D-CCD0-7329496A2D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4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" name="Line 171">
              <a:extLst>
                <a:ext uri="{FF2B5EF4-FFF2-40B4-BE49-F238E27FC236}">
                  <a16:creationId xmlns:a16="http://schemas.microsoft.com/office/drawing/2014/main" id="{98361BD2-6831-BE51-C8BB-7139384281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02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Line 172">
              <a:extLst>
                <a:ext uri="{FF2B5EF4-FFF2-40B4-BE49-F238E27FC236}">
                  <a16:creationId xmlns:a16="http://schemas.microsoft.com/office/drawing/2014/main" id="{9BD7DCF1-C099-2841-8E40-EC1EEFE0EE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0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" name="Line 173">
              <a:extLst>
                <a:ext uri="{FF2B5EF4-FFF2-40B4-BE49-F238E27FC236}">
                  <a16:creationId xmlns:a16="http://schemas.microsoft.com/office/drawing/2014/main" id="{B5005064-EDFF-31BD-AA72-0C6A75C64F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99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" name="Rectangle 174">
              <a:extLst>
                <a:ext uri="{FF2B5EF4-FFF2-40B4-BE49-F238E27FC236}">
                  <a16:creationId xmlns:a16="http://schemas.microsoft.com/office/drawing/2014/main" id="{74B729E7-C257-30EF-696A-42B3013F37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4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8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Rectangle 175">
              <a:extLst>
                <a:ext uri="{FF2B5EF4-FFF2-40B4-BE49-F238E27FC236}">
                  <a16:creationId xmlns:a16="http://schemas.microsoft.com/office/drawing/2014/main" id="{EC22E506-9A8C-081E-50AC-758ECEC3C5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7" name="Rectangle 176">
              <a:extLst>
                <a:ext uri="{FF2B5EF4-FFF2-40B4-BE49-F238E27FC236}">
                  <a16:creationId xmlns:a16="http://schemas.microsoft.com/office/drawing/2014/main" id="{D86F84A8-3EB4-5704-C195-E0FED0EBB7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Rectangle 177">
              <a:extLst>
                <a:ext uri="{FF2B5EF4-FFF2-40B4-BE49-F238E27FC236}">
                  <a16:creationId xmlns:a16="http://schemas.microsoft.com/office/drawing/2014/main" id="{12C43EDC-B6CD-8325-6595-E91029C1DB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9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9" name="Rectangle 178">
              <a:extLst>
                <a:ext uri="{FF2B5EF4-FFF2-40B4-BE49-F238E27FC236}">
                  <a16:creationId xmlns:a16="http://schemas.microsoft.com/office/drawing/2014/main" id="{7C6F6C9A-2CD8-D0A3-C912-42C9511E10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5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Rectangle 179">
              <a:extLst>
                <a:ext uri="{FF2B5EF4-FFF2-40B4-BE49-F238E27FC236}">
                  <a16:creationId xmlns:a16="http://schemas.microsoft.com/office/drawing/2014/main" id="{C6C72A0E-68FD-12CF-D833-4B281E34F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7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Rectangle 180">
              <a:extLst>
                <a:ext uri="{FF2B5EF4-FFF2-40B4-BE49-F238E27FC236}">
                  <a16:creationId xmlns:a16="http://schemas.microsoft.com/office/drawing/2014/main" id="{70A64674-E37F-9DD1-09F4-7ACA4FA2C5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5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Rectangle 181">
              <a:extLst>
                <a:ext uri="{FF2B5EF4-FFF2-40B4-BE49-F238E27FC236}">
                  <a16:creationId xmlns:a16="http://schemas.microsoft.com/office/drawing/2014/main" id="{C47EBB74-327A-8CCE-3E86-77B11ABC74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4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Rectangle 182">
              <a:extLst>
                <a:ext uri="{FF2B5EF4-FFF2-40B4-BE49-F238E27FC236}">
                  <a16:creationId xmlns:a16="http://schemas.microsoft.com/office/drawing/2014/main" id="{F54B2895-9E4A-90A0-66C9-93BF7B42FD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2" y="3065"/>
              <a:ext cx="230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r>
                <a:rPr kumimoji="0" lang="ja-JP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≤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Rectangle 183">
              <a:extLst>
                <a:ext uri="{FF2B5EF4-FFF2-40B4-BE49-F238E27FC236}">
                  <a16:creationId xmlns:a16="http://schemas.microsoft.com/office/drawing/2014/main" id="{4B82C674-42A8-76E3-ADCB-3820E76A7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698"/>
              <a:ext cx="62" cy="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5" name="Rectangle 184">
              <a:extLst>
                <a:ext uri="{FF2B5EF4-FFF2-40B4-BE49-F238E27FC236}">
                  <a16:creationId xmlns:a16="http://schemas.microsoft.com/office/drawing/2014/main" id="{9B5C2DB8-9CE7-EEC4-334F-9408A0ADE2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698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" name="Rectangle 185">
              <a:extLst>
                <a:ext uri="{FF2B5EF4-FFF2-40B4-BE49-F238E27FC236}">
                  <a16:creationId xmlns:a16="http://schemas.microsoft.com/office/drawing/2014/main" id="{0292E2B2-850C-6508-F357-FFC24CA598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975"/>
              <a:ext cx="62" cy="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7" name="Rectangle 186">
              <a:extLst>
                <a:ext uri="{FF2B5EF4-FFF2-40B4-BE49-F238E27FC236}">
                  <a16:creationId xmlns:a16="http://schemas.microsoft.com/office/drawing/2014/main" id="{535B68D5-732D-6D31-64D8-2B7AD5FAE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975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1" name="Line 190">
              <a:extLst>
                <a:ext uri="{FF2B5EF4-FFF2-40B4-BE49-F238E27FC236}">
                  <a16:creationId xmlns:a16="http://schemas.microsoft.com/office/drawing/2014/main" id="{69A5F90D-16D0-AB2B-947D-38EE5BD61E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1" y="633"/>
              <a:ext cx="0" cy="229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2" name="Line 191">
              <a:extLst>
                <a:ext uri="{FF2B5EF4-FFF2-40B4-BE49-F238E27FC236}">
                  <a16:creationId xmlns:a16="http://schemas.microsoft.com/office/drawing/2014/main" id="{C3FC01DB-86FE-B888-7392-453AFD71EB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93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Line 192">
              <a:extLst>
                <a:ext uri="{FF2B5EF4-FFF2-40B4-BE49-F238E27FC236}">
                  <a16:creationId xmlns:a16="http://schemas.microsoft.com/office/drawing/2014/main" id="{BC574994-C8B4-AB28-0FDC-885F3F810D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60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" name="Line 193">
              <a:extLst>
                <a:ext uri="{FF2B5EF4-FFF2-40B4-BE49-F238E27FC236}">
                  <a16:creationId xmlns:a16="http://schemas.microsoft.com/office/drawing/2014/main" id="{DC45AAF3-7697-5D51-51B9-A088179652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273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" name="Line 194">
              <a:extLst>
                <a:ext uri="{FF2B5EF4-FFF2-40B4-BE49-F238E27FC236}">
                  <a16:creationId xmlns:a16="http://schemas.microsoft.com/office/drawing/2014/main" id="{8BDA51B0-04D0-4A80-EB97-27C36C2EAD9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944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" name="Line 195">
              <a:extLst>
                <a:ext uri="{FF2B5EF4-FFF2-40B4-BE49-F238E27FC236}">
                  <a16:creationId xmlns:a16="http://schemas.microsoft.com/office/drawing/2014/main" id="{46E94774-E550-B3BA-E6B9-B16EA5D325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615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7" name="Line 196">
              <a:extLst>
                <a:ext uri="{FF2B5EF4-FFF2-40B4-BE49-F238E27FC236}">
                  <a16:creationId xmlns:a16="http://schemas.microsoft.com/office/drawing/2014/main" id="{2C9CDEB2-573D-EFFE-658F-432831B2E0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291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8" name="Line 197">
              <a:extLst>
                <a:ext uri="{FF2B5EF4-FFF2-40B4-BE49-F238E27FC236}">
                  <a16:creationId xmlns:a16="http://schemas.microsoft.com/office/drawing/2014/main" id="{B95CDF55-4A8E-0413-E581-FEF32A85B0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96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9" name="Line 198">
              <a:extLst>
                <a:ext uri="{FF2B5EF4-FFF2-40B4-BE49-F238E27FC236}">
                  <a16:creationId xmlns:a16="http://schemas.microsoft.com/office/drawing/2014/main" id="{923D2B99-8D90-30AB-61F2-52CA5200CC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633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Rectangle 199">
              <a:extLst>
                <a:ext uri="{FF2B5EF4-FFF2-40B4-BE49-F238E27FC236}">
                  <a16:creationId xmlns:a16="http://schemas.microsoft.com/office/drawing/2014/main" id="{B88DB9CD-05A5-B562-5A92-9B4235AC6A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" y="2896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Rectangle 200">
              <a:extLst>
                <a:ext uri="{FF2B5EF4-FFF2-40B4-BE49-F238E27FC236}">
                  <a16:creationId xmlns:a16="http://schemas.microsoft.com/office/drawing/2014/main" id="{52158F86-937C-3885-4891-F57C440247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2566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Rectangle 201">
              <a:extLst>
                <a:ext uri="{FF2B5EF4-FFF2-40B4-BE49-F238E27FC236}">
                  <a16:creationId xmlns:a16="http://schemas.microsoft.com/office/drawing/2014/main" id="{F4549F91-AF6B-0051-9DD0-4F81D8D4EE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2242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202">
              <a:extLst>
                <a:ext uri="{FF2B5EF4-FFF2-40B4-BE49-F238E27FC236}">
                  <a16:creationId xmlns:a16="http://schemas.microsoft.com/office/drawing/2014/main" id="{213569A3-23A8-CDE4-F3DC-A23046C442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913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Rectangle 203">
              <a:extLst>
                <a:ext uri="{FF2B5EF4-FFF2-40B4-BE49-F238E27FC236}">
                  <a16:creationId xmlns:a16="http://schemas.microsoft.com/office/drawing/2014/main" id="{CDCECDC7-21B4-DD50-436E-5C9BF8E1F0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584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Rectangle 204">
              <a:extLst>
                <a:ext uri="{FF2B5EF4-FFF2-40B4-BE49-F238E27FC236}">
                  <a16:creationId xmlns:a16="http://schemas.microsoft.com/office/drawing/2014/main" id="{138E41B0-8EED-4082-E19D-428DB97F85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25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6" name="Rectangle 205">
              <a:extLst>
                <a:ext uri="{FF2B5EF4-FFF2-40B4-BE49-F238E27FC236}">
                  <a16:creationId xmlns:a16="http://schemas.microsoft.com/office/drawing/2014/main" id="{2DB73D2D-563F-2A3C-C516-88301560E5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926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Rectangle 206">
              <a:extLst>
                <a:ext uri="{FF2B5EF4-FFF2-40B4-BE49-F238E27FC236}">
                  <a16:creationId xmlns:a16="http://schemas.microsoft.com/office/drawing/2014/main" id="{6D9C81FD-45C4-8415-C613-BDDDABD560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597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22" name="Group 209">
            <a:extLst>
              <a:ext uri="{FF2B5EF4-FFF2-40B4-BE49-F238E27FC236}">
                <a16:creationId xmlns:a16="http://schemas.microsoft.com/office/drawing/2014/main" id="{4C38C08F-714C-35D3-B582-0E7103DA110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02000" y="3879234"/>
            <a:ext cx="2868890" cy="2655540"/>
            <a:chOff x="1849" y="401"/>
            <a:chExt cx="3039" cy="2813"/>
          </a:xfrm>
        </p:grpSpPr>
        <p:sp>
          <p:nvSpPr>
            <p:cNvPr id="224" name="Rectangle 210">
              <a:extLst>
                <a:ext uri="{FF2B5EF4-FFF2-40B4-BE49-F238E27FC236}">
                  <a16:creationId xmlns:a16="http://schemas.microsoft.com/office/drawing/2014/main" id="{6D0AA645-7B4C-8E88-474F-C7010B43A0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880"/>
              <a:ext cx="7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5" name="Rectangle 211">
              <a:extLst>
                <a:ext uri="{FF2B5EF4-FFF2-40B4-BE49-F238E27FC236}">
                  <a16:creationId xmlns:a16="http://schemas.microsoft.com/office/drawing/2014/main" id="{08809655-04F3-D1B4-D06F-8B51E9F6EE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880"/>
              <a:ext cx="7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Rectangle 212">
              <a:extLst>
                <a:ext uri="{FF2B5EF4-FFF2-40B4-BE49-F238E27FC236}">
                  <a16:creationId xmlns:a16="http://schemas.microsoft.com/office/drawing/2014/main" id="{835EA0F1-84F5-9E0E-1EC9-2E6F20318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1" y="2829"/>
              <a:ext cx="77" cy="10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Rectangle 213">
              <a:extLst>
                <a:ext uri="{FF2B5EF4-FFF2-40B4-BE49-F238E27FC236}">
                  <a16:creationId xmlns:a16="http://schemas.microsoft.com/office/drawing/2014/main" id="{CB3296AD-B104-C28A-173B-71CFA18C6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1" y="2829"/>
              <a:ext cx="77" cy="10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Rectangle 214">
              <a:extLst>
                <a:ext uri="{FF2B5EF4-FFF2-40B4-BE49-F238E27FC236}">
                  <a16:creationId xmlns:a16="http://schemas.microsoft.com/office/drawing/2014/main" id="{A7B9B5B2-5B23-2ADB-2B50-C7DC8C15F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4" y="2932"/>
              <a:ext cx="77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Rectangle 215">
              <a:extLst>
                <a:ext uri="{FF2B5EF4-FFF2-40B4-BE49-F238E27FC236}">
                  <a16:creationId xmlns:a16="http://schemas.microsoft.com/office/drawing/2014/main" id="{743000F3-37A9-8D0A-8D03-91A1B01471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4" y="2932"/>
              <a:ext cx="77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Rectangle 216">
              <a:extLst>
                <a:ext uri="{FF2B5EF4-FFF2-40B4-BE49-F238E27FC236}">
                  <a16:creationId xmlns:a16="http://schemas.microsoft.com/office/drawing/2014/main" id="{A46B58C2-F304-DD0D-C9F5-1F1394865E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1" y="2829"/>
              <a:ext cx="72" cy="10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" name="Rectangle 217">
              <a:extLst>
                <a:ext uri="{FF2B5EF4-FFF2-40B4-BE49-F238E27FC236}">
                  <a16:creationId xmlns:a16="http://schemas.microsoft.com/office/drawing/2014/main" id="{556074EE-78DD-0E4A-5565-5836DDD140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1" y="2829"/>
              <a:ext cx="72" cy="10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Rectangle 218">
              <a:extLst>
                <a:ext uri="{FF2B5EF4-FFF2-40B4-BE49-F238E27FC236}">
                  <a16:creationId xmlns:a16="http://schemas.microsoft.com/office/drawing/2014/main" id="{B6401550-DC15-01F0-4281-D2D77BAA0B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" y="2932"/>
              <a:ext cx="72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Rectangle 219">
              <a:extLst>
                <a:ext uri="{FF2B5EF4-FFF2-40B4-BE49-F238E27FC236}">
                  <a16:creationId xmlns:a16="http://schemas.microsoft.com/office/drawing/2014/main" id="{716ACAC4-FCB0-E269-1D78-58CEAD2F5E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" y="2932"/>
              <a:ext cx="72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Rectangle 220">
              <a:extLst>
                <a:ext uri="{FF2B5EF4-FFF2-40B4-BE49-F238E27FC236}">
                  <a16:creationId xmlns:a16="http://schemas.microsoft.com/office/drawing/2014/main" id="{0247BBAD-3A0F-B57E-0A72-B19A49930B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6" y="2726"/>
              <a:ext cx="77" cy="206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Rectangle 221">
              <a:extLst>
                <a:ext uri="{FF2B5EF4-FFF2-40B4-BE49-F238E27FC236}">
                  <a16:creationId xmlns:a16="http://schemas.microsoft.com/office/drawing/2014/main" id="{00C0EEA4-8D9D-7D19-370C-0C79D263BC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6" y="2726"/>
              <a:ext cx="77" cy="20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Rectangle 222">
              <a:extLst>
                <a:ext uri="{FF2B5EF4-FFF2-40B4-BE49-F238E27FC236}">
                  <a16:creationId xmlns:a16="http://schemas.microsoft.com/office/drawing/2014/main" id="{1071ADDD-9515-A446-CA83-9D711EF5FD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9" y="2880"/>
              <a:ext cx="77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Rectangle 223">
              <a:extLst>
                <a:ext uri="{FF2B5EF4-FFF2-40B4-BE49-F238E27FC236}">
                  <a16:creationId xmlns:a16="http://schemas.microsoft.com/office/drawing/2014/main" id="{390EB339-1213-AA31-B97D-B6B35A2CB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9" y="2880"/>
              <a:ext cx="77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Rectangle 224">
              <a:extLst>
                <a:ext uri="{FF2B5EF4-FFF2-40B4-BE49-F238E27FC236}">
                  <a16:creationId xmlns:a16="http://schemas.microsoft.com/office/drawing/2014/main" id="{2FE9F23A-A747-786C-4DD6-28B167C82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6" y="2412"/>
              <a:ext cx="72" cy="52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Rectangle 225">
              <a:extLst>
                <a:ext uri="{FF2B5EF4-FFF2-40B4-BE49-F238E27FC236}">
                  <a16:creationId xmlns:a16="http://schemas.microsoft.com/office/drawing/2014/main" id="{EBD6265D-1210-1EE2-E622-0C51F6130A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6" y="2412"/>
              <a:ext cx="72" cy="52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Rectangle 226">
              <a:extLst>
                <a:ext uri="{FF2B5EF4-FFF2-40B4-BE49-F238E27FC236}">
                  <a16:creationId xmlns:a16="http://schemas.microsoft.com/office/drawing/2014/main" id="{1F6E6A1D-A6E7-E69D-F610-3D06029CAA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9" y="2674"/>
              <a:ext cx="72" cy="258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Rectangle 227">
              <a:extLst>
                <a:ext uri="{FF2B5EF4-FFF2-40B4-BE49-F238E27FC236}">
                  <a16:creationId xmlns:a16="http://schemas.microsoft.com/office/drawing/2014/main" id="{C56C66CA-547F-6A6B-9CF1-E2D5A4E23A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9" y="2674"/>
              <a:ext cx="72" cy="25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" name="Rectangle 228">
              <a:extLst>
                <a:ext uri="{FF2B5EF4-FFF2-40B4-BE49-F238E27FC236}">
                  <a16:creationId xmlns:a16="http://schemas.microsoft.com/office/drawing/2014/main" id="{CF3F2E66-3917-7717-4C71-5CF9CF2A91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" y="2206"/>
              <a:ext cx="77" cy="726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Rectangle 229">
              <a:extLst>
                <a:ext uri="{FF2B5EF4-FFF2-40B4-BE49-F238E27FC236}">
                  <a16:creationId xmlns:a16="http://schemas.microsoft.com/office/drawing/2014/main" id="{F148FC86-02E0-BA3F-4D3C-94F5021808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" y="2206"/>
              <a:ext cx="77" cy="72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Rectangle 230">
              <a:extLst>
                <a:ext uri="{FF2B5EF4-FFF2-40B4-BE49-F238E27FC236}">
                  <a16:creationId xmlns:a16="http://schemas.microsoft.com/office/drawing/2014/main" id="{45CC800F-952D-B835-5669-742B44529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9" y="2566"/>
              <a:ext cx="72" cy="366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Rectangle 231">
              <a:extLst>
                <a:ext uri="{FF2B5EF4-FFF2-40B4-BE49-F238E27FC236}">
                  <a16:creationId xmlns:a16="http://schemas.microsoft.com/office/drawing/2014/main" id="{A8EC6E91-6499-4AFF-54DE-6D6CF1E16F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9" y="2566"/>
              <a:ext cx="72" cy="36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Rectangle 232">
              <a:extLst>
                <a:ext uri="{FF2B5EF4-FFF2-40B4-BE49-F238E27FC236}">
                  <a16:creationId xmlns:a16="http://schemas.microsoft.com/office/drawing/2014/main" id="{CEF0774E-B1F1-1841-9C24-BDA404478E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1" y="1744"/>
              <a:ext cx="72" cy="1188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Rectangle 233">
              <a:extLst>
                <a:ext uri="{FF2B5EF4-FFF2-40B4-BE49-F238E27FC236}">
                  <a16:creationId xmlns:a16="http://schemas.microsoft.com/office/drawing/2014/main" id="{E74AC5B5-2E2F-773A-C20B-E263F6F59E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1" y="1744"/>
              <a:ext cx="72" cy="118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" name="Rectangle 234">
              <a:extLst>
                <a:ext uri="{FF2B5EF4-FFF2-40B4-BE49-F238E27FC236}">
                  <a16:creationId xmlns:a16="http://schemas.microsoft.com/office/drawing/2014/main" id="{CD67AD56-A13F-FB24-C72C-0E4737734C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" y="1898"/>
              <a:ext cx="77" cy="103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Rectangle 235">
              <a:extLst>
                <a:ext uri="{FF2B5EF4-FFF2-40B4-BE49-F238E27FC236}">
                  <a16:creationId xmlns:a16="http://schemas.microsoft.com/office/drawing/2014/main" id="{4980C5F9-028D-BA00-59DA-720E97521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" y="1898"/>
              <a:ext cx="77" cy="103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Rectangle 236">
              <a:extLst>
                <a:ext uri="{FF2B5EF4-FFF2-40B4-BE49-F238E27FC236}">
                  <a16:creationId xmlns:a16="http://schemas.microsoft.com/office/drawing/2014/main" id="{9866066B-3DCA-CB4D-25D1-2D70AFCAC8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1" y="1229"/>
              <a:ext cx="72" cy="170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" name="Rectangle 237">
              <a:extLst>
                <a:ext uri="{FF2B5EF4-FFF2-40B4-BE49-F238E27FC236}">
                  <a16:creationId xmlns:a16="http://schemas.microsoft.com/office/drawing/2014/main" id="{F3C3EF44-4BEB-BC41-8942-CF052F3CB1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1" y="1229"/>
              <a:ext cx="72" cy="170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" name="Rectangle 238">
              <a:extLst>
                <a:ext uri="{FF2B5EF4-FFF2-40B4-BE49-F238E27FC236}">
                  <a16:creationId xmlns:a16="http://schemas.microsoft.com/office/drawing/2014/main" id="{E374CD7D-A835-848C-BDD4-E59A232C8F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4" y="1898"/>
              <a:ext cx="72" cy="103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" name="Rectangle 239">
              <a:extLst>
                <a:ext uri="{FF2B5EF4-FFF2-40B4-BE49-F238E27FC236}">
                  <a16:creationId xmlns:a16="http://schemas.microsoft.com/office/drawing/2014/main" id="{41E853E5-DB5F-A7E9-1544-C93E752301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4" y="1898"/>
              <a:ext cx="72" cy="103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Rectangle 240">
              <a:extLst>
                <a:ext uri="{FF2B5EF4-FFF2-40B4-BE49-F238E27FC236}">
                  <a16:creationId xmlns:a16="http://schemas.microsoft.com/office/drawing/2014/main" id="{0A1E052A-B6F6-F96B-2F14-28B44522C0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401"/>
              <a:ext cx="77" cy="253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Rectangle 241">
              <a:extLst>
                <a:ext uri="{FF2B5EF4-FFF2-40B4-BE49-F238E27FC236}">
                  <a16:creationId xmlns:a16="http://schemas.microsoft.com/office/drawing/2014/main" id="{BD06B562-8B67-C4FB-A598-10E20424E4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401"/>
              <a:ext cx="77" cy="253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Rectangle 242">
              <a:extLst>
                <a:ext uri="{FF2B5EF4-FFF2-40B4-BE49-F238E27FC236}">
                  <a16:creationId xmlns:a16="http://schemas.microsoft.com/office/drawing/2014/main" id="{6E93E44D-CF6C-9814-1038-C9E406231D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9" y="1795"/>
              <a:ext cx="77" cy="113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Rectangle 243">
              <a:extLst>
                <a:ext uri="{FF2B5EF4-FFF2-40B4-BE49-F238E27FC236}">
                  <a16:creationId xmlns:a16="http://schemas.microsoft.com/office/drawing/2014/main" id="{2126D235-D251-0BBE-EC4E-AAB39C921A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9" y="1795"/>
              <a:ext cx="77" cy="113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Rectangle 244">
              <a:extLst>
                <a:ext uri="{FF2B5EF4-FFF2-40B4-BE49-F238E27FC236}">
                  <a16:creationId xmlns:a16="http://schemas.microsoft.com/office/drawing/2014/main" id="{050C4B53-50A5-1ECD-F7EA-9FB189E506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6" y="555"/>
              <a:ext cx="72" cy="237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" name="Rectangle 245">
              <a:extLst>
                <a:ext uri="{FF2B5EF4-FFF2-40B4-BE49-F238E27FC236}">
                  <a16:creationId xmlns:a16="http://schemas.microsoft.com/office/drawing/2014/main" id="{C52E8B63-3A44-3F5B-BA63-61C143A63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6" y="555"/>
              <a:ext cx="72" cy="237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" name="Rectangle 246">
              <a:extLst>
                <a:ext uri="{FF2B5EF4-FFF2-40B4-BE49-F238E27FC236}">
                  <a16:creationId xmlns:a16="http://schemas.microsoft.com/office/drawing/2014/main" id="{BBF1268A-F559-3869-3257-696E35147D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9" y="2258"/>
              <a:ext cx="72" cy="67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Rectangle 247">
              <a:extLst>
                <a:ext uri="{FF2B5EF4-FFF2-40B4-BE49-F238E27FC236}">
                  <a16:creationId xmlns:a16="http://schemas.microsoft.com/office/drawing/2014/main" id="{DEC8184B-BEC3-C9DE-335C-5678D3DCAA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9" y="2258"/>
              <a:ext cx="72" cy="67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Rectangle 248">
              <a:extLst>
                <a:ext uri="{FF2B5EF4-FFF2-40B4-BE49-F238E27FC236}">
                  <a16:creationId xmlns:a16="http://schemas.microsoft.com/office/drawing/2014/main" id="{D65B552F-75D2-CBCD-C3EB-3650EB2BD6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1" y="1589"/>
              <a:ext cx="77" cy="1343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Rectangle 249">
              <a:extLst>
                <a:ext uri="{FF2B5EF4-FFF2-40B4-BE49-F238E27FC236}">
                  <a16:creationId xmlns:a16="http://schemas.microsoft.com/office/drawing/2014/main" id="{FD4EEF35-9FFC-11E0-7ABB-462299DB2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1" y="1589"/>
              <a:ext cx="77" cy="134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Rectangle 250">
              <a:extLst>
                <a:ext uri="{FF2B5EF4-FFF2-40B4-BE49-F238E27FC236}">
                  <a16:creationId xmlns:a16="http://schemas.microsoft.com/office/drawing/2014/main" id="{8D616258-647C-66D6-5747-8DA90DD773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9" y="2618"/>
              <a:ext cx="72" cy="31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Rectangle 251">
              <a:extLst>
                <a:ext uri="{FF2B5EF4-FFF2-40B4-BE49-F238E27FC236}">
                  <a16:creationId xmlns:a16="http://schemas.microsoft.com/office/drawing/2014/main" id="{B0DE9B31-D2F1-F3D7-D9FA-57A362E355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9" y="2618"/>
              <a:ext cx="72" cy="31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Rectangle 252">
              <a:extLst>
                <a:ext uri="{FF2B5EF4-FFF2-40B4-BE49-F238E27FC236}">
                  <a16:creationId xmlns:a16="http://schemas.microsoft.com/office/drawing/2014/main" id="{C401C2B6-6E71-22B4-B29A-92AE2F85F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1" y="2052"/>
              <a:ext cx="72" cy="88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Rectangle 253">
              <a:extLst>
                <a:ext uri="{FF2B5EF4-FFF2-40B4-BE49-F238E27FC236}">
                  <a16:creationId xmlns:a16="http://schemas.microsoft.com/office/drawing/2014/main" id="{089C43E1-ED2D-DD91-B366-956609C5E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1" y="2052"/>
              <a:ext cx="72" cy="88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Rectangle 254">
              <a:extLst>
                <a:ext uri="{FF2B5EF4-FFF2-40B4-BE49-F238E27FC236}">
                  <a16:creationId xmlns:a16="http://schemas.microsoft.com/office/drawing/2014/main" id="{81DDD56D-C8BA-E1DF-04FF-04286941D2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4" y="2618"/>
              <a:ext cx="77" cy="31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Rectangle 255">
              <a:extLst>
                <a:ext uri="{FF2B5EF4-FFF2-40B4-BE49-F238E27FC236}">
                  <a16:creationId xmlns:a16="http://schemas.microsoft.com/office/drawing/2014/main" id="{BE6B4215-755C-606A-0170-90423C4042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4" y="2618"/>
              <a:ext cx="77" cy="31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Rectangle 256">
              <a:extLst>
                <a:ext uri="{FF2B5EF4-FFF2-40B4-BE49-F238E27FC236}">
                  <a16:creationId xmlns:a16="http://schemas.microsoft.com/office/drawing/2014/main" id="{C4EEDC36-5639-914E-D4DE-9706B08748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1" y="2515"/>
              <a:ext cx="72" cy="41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Rectangle 257">
              <a:extLst>
                <a:ext uri="{FF2B5EF4-FFF2-40B4-BE49-F238E27FC236}">
                  <a16:creationId xmlns:a16="http://schemas.microsoft.com/office/drawing/2014/main" id="{925D99AB-0A7A-AD28-9470-72ED4FB163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1" y="2515"/>
              <a:ext cx="72" cy="41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Rectangle 258">
              <a:extLst>
                <a:ext uri="{FF2B5EF4-FFF2-40B4-BE49-F238E27FC236}">
                  <a16:creationId xmlns:a16="http://schemas.microsoft.com/office/drawing/2014/main" id="{F0DCED96-9BB0-87B7-0797-B6C68E192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4" y="2777"/>
              <a:ext cx="72" cy="155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Rectangle 259">
              <a:extLst>
                <a:ext uri="{FF2B5EF4-FFF2-40B4-BE49-F238E27FC236}">
                  <a16:creationId xmlns:a16="http://schemas.microsoft.com/office/drawing/2014/main" id="{14C64949-4F71-9593-E575-7EFFF068E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4" y="2777"/>
              <a:ext cx="72" cy="15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Rectangle 260">
              <a:extLst>
                <a:ext uri="{FF2B5EF4-FFF2-40B4-BE49-F238E27FC236}">
                  <a16:creationId xmlns:a16="http://schemas.microsoft.com/office/drawing/2014/main" id="{BBDE6D82-7092-87BC-5D1D-9E1292DF81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6" y="2674"/>
              <a:ext cx="77" cy="258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Rectangle 261">
              <a:extLst>
                <a:ext uri="{FF2B5EF4-FFF2-40B4-BE49-F238E27FC236}">
                  <a16:creationId xmlns:a16="http://schemas.microsoft.com/office/drawing/2014/main" id="{BA2806CD-039A-AE86-240F-9BAAEFD1DD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6" y="2674"/>
              <a:ext cx="77" cy="25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Rectangle 262">
              <a:extLst>
                <a:ext uri="{FF2B5EF4-FFF2-40B4-BE49-F238E27FC236}">
                  <a16:creationId xmlns:a16="http://schemas.microsoft.com/office/drawing/2014/main" id="{14AA15F8-A09A-6FD6-9696-25AE117C8C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9" y="2880"/>
              <a:ext cx="77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Rectangle 263">
              <a:extLst>
                <a:ext uri="{FF2B5EF4-FFF2-40B4-BE49-F238E27FC236}">
                  <a16:creationId xmlns:a16="http://schemas.microsoft.com/office/drawing/2014/main" id="{29AC9280-47F6-8AF7-0CDC-8FCE424EDB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9" y="2880"/>
              <a:ext cx="77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Rectangle 264">
              <a:extLst>
                <a:ext uri="{FF2B5EF4-FFF2-40B4-BE49-F238E27FC236}">
                  <a16:creationId xmlns:a16="http://schemas.microsoft.com/office/drawing/2014/main" id="{CF1C78D2-BA1E-4471-AF0D-AA9134FD8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6" y="2880"/>
              <a:ext cx="72" cy="5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Rectangle 265">
              <a:extLst>
                <a:ext uri="{FF2B5EF4-FFF2-40B4-BE49-F238E27FC236}">
                  <a16:creationId xmlns:a16="http://schemas.microsoft.com/office/drawing/2014/main" id="{2373D59A-7EB9-0540-95EF-279CEAD749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6" y="2880"/>
              <a:ext cx="7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Rectangle 266">
              <a:extLst>
                <a:ext uri="{FF2B5EF4-FFF2-40B4-BE49-F238E27FC236}">
                  <a16:creationId xmlns:a16="http://schemas.microsoft.com/office/drawing/2014/main" id="{B93224A6-93AD-00BF-642D-215745C156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9" y="2880"/>
              <a:ext cx="72" cy="5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Rectangle 267">
              <a:extLst>
                <a:ext uri="{FF2B5EF4-FFF2-40B4-BE49-F238E27FC236}">
                  <a16:creationId xmlns:a16="http://schemas.microsoft.com/office/drawing/2014/main" id="{A7789DA6-4C6C-4AC0-2BCE-2EA8620461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9" y="2880"/>
              <a:ext cx="72" cy="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Rectangle 268">
              <a:extLst>
                <a:ext uri="{FF2B5EF4-FFF2-40B4-BE49-F238E27FC236}">
                  <a16:creationId xmlns:a16="http://schemas.microsoft.com/office/drawing/2014/main" id="{CE6C312E-0BE4-81FD-E16D-7E2A28093F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1" y="2932"/>
              <a:ext cx="77" cy="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Rectangle 269">
              <a:extLst>
                <a:ext uri="{FF2B5EF4-FFF2-40B4-BE49-F238E27FC236}">
                  <a16:creationId xmlns:a16="http://schemas.microsoft.com/office/drawing/2014/main" id="{9C012170-669A-27F9-0A71-2883C0475C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1" y="2932"/>
              <a:ext cx="77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Line 270">
              <a:extLst>
                <a:ext uri="{FF2B5EF4-FFF2-40B4-BE49-F238E27FC236}">
                  <a16:creationId xmlns:a16="http://schemas.microsoft.com/office/drawing/2014/main" id="{2B33B3BC-B78F-320B-058D-F81676E86D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1" y="2957"/>
              <a:ext cx="249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Line 271">
              <a:extLst>
                <a:ext uri="{FF2B5EF4-FFF2-40B4-BE49-F238E27FC236}">
                  <a16:creationId xmlns:a16="http://schemas.microsoft.com/office/drawing/2014/main" id="{45CDEC2E-64C5-7E74-EA1A-DA53F8765C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Line 272">
              <a:extLst>
                <a:ext uri="{FF2B5EF4-FFF2-40B4-BE49-F238E27FC236}">
                  <a16:creationId xmlns:a16="http://schemas.microsoft.com/office/drawing/2014/main" id="{EF4780DB-1059-95A8-3605-F96DD92A49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7" name="Line 273">
              <a:extLst>
                <a:ext uri="{FF2B5EF4-FFF2-40B4-BE49-F238E27FC236}">
                  <a16:creationId xmlns:a16="http://schemas.microsoft.com/office/drawing/2014/main" id="{325A2587-F2E7-A334-D26F-8623DDB63A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Line 274">
              <a:extLst>
                <a:ext uri="{FF2B5EF4-FFF2-40B4-BE49-F238E27FC236}">
                  <a16:creationId xmlns:a16="http://schemas.microsoft.com/office/drawing/2014/main" id="{308C1E82-ABDA-F420-8D42-DDBDE4E980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Line 275">
              <a:extLst>
                <a:ext uri="{FF2B5EF4-FFF2-40B4-BE49-F238E27FC236}">
                  <a16:creationId xmlns:a16="http://schemas.microsoft.com/office/drawing/2014/main" id="{28CE6C55-088E-156B-709B-6CA829C68D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Line 276">
              <a:extLst>
                <a:ext uri="{FF2B5EF4-FFF2-40B4-BE49-F238E27FC236}">
                  <a16:creationId xmlns:a16="http://schemas.microsoft.com/office/drawing/2014/main" id="{29B623DA-7BE0-C5A8-9E78-335F3CDE7F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Line 277">
              <a:extLst>
                <a:ext uri="{FF2B5EF4-FFF2-40B4-BE49-F238E27FC236}">
                  <a16:creationId xmlns:a16="http://schemas.microsoft.com/office/drawing/2014/main" id="{7E1B0B21-52FA-9988-990E-418EEF4519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Line 278">
              <a:extLst>
                <a:ext uri="{FF2B5EF4-FFF2-40B4-BE49-F238E27FC236}">
                  <a16:creationId xmlns:a16="http://schemas.microsoft.com/office/drawing/2014/main" id="{D2D1EF26-E220-EC6A-7408-EB6B965837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Line 279">
              <a:extLst>
                <a:ext uri="{FF2B5EF4-FFF2-40B4-BE49-F238E27FC236}">
                  <a16:creationId xmlns:a16="http://schemas.microsoft.com/office/drawing/2014/main" id="{BBFCA9A7-3255-4D9E-AF43-BB6AB97E8F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Line 280">
              <a:extLst>
                <a:ext uri="{FF2B5EF4-FFF2-40B4-BE49-F238E27FC236}">
                  <a16:creationId xmlns:a16="http://schemas.microsoft.com/office/drawing/2014/main" id="{C883E1B6-6DBC-ADE2-E798-D643746B57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Line 281">
              <a:extLst>
                <a:ext uri="{FF2B5EF4-FFF2-40B4-BE49-F238E27FC236}">
                  <a16:creationId xmlns:a16="http://schemas.microsoft.com/office/drawing/2014/main" id="{1D770696-A8E6-5054-4663-9427332FB4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4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Line 282">
              <a:extLst>
                <a:ext uri="{FF2B5EF4-FFF2-40B4-BE49-F238E27FC236}">
                  <a16:creationId xmlns:a16="http://schemas.microsoft.com/office/drawing/2014/main" id="{21596DFA-7FA7-BA7C-B8E9-490EE8370A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2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Line 283">
              <a:extLst>
                <a:ext uri="{FF2B5EF4-FFF2-40B4-BE49-F238E27FC236}">
                  <a16:creationId xmlns:a16="http://schemas.microsoft.com/office/drawing/2014/main" id="{7DD10C1E-5289-FAA3-E291-16A514D7CE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9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Line 284">
              <a:extLst>
                <a:ext uri="{FF2B5EF4-FFF2-40B4-BE49-F238E27FC236}">
                  <a16:creationId xmlns:a16="http://schemas.microsoft.com/office/drawing/2014/main" id="{8290D057-67D1-BE6E-0069-388F61E07F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Line 285">
              <a:extLst>
                <a:ext uri="{FF2B5EF4-FFF2-40B4-BE49-F238E27FC236}">
                  <a16:creationId xmlns:a16="http://schemas.microsoft.com/office/drawing/2014/main" id="{54BDA66F-38C3-0768-8800-CB19DE2C60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5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Rectangle 286">
              <a:extLst>
                <a:ext uri="{FF2B5EF4-FFF2-40B4-BE49-F238E27FC236}">
                  <a16:creationId xmlns:a16="http://schemas.microsoft.com/office/drawing/2014/main" id="{27965BE5-0747-0AE2-1F36-52DE983D99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8" y="3065"/>
              <a:ext cx="246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≤</a:t>
              </a: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1" name="Rectangle 287">
              <a:extLst>
                <a:ext uri="{FF2B5EF4-FFF2-40B4-BE49-F238E27FC236}">
                  <a16:creationId xmlns:a16="http://schemas.microsoft.com/office/drawing/2014/main" id="{44D288A3-2967-CE03-E919-E9795BC8B6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7" y="3065"/>
              <a:ext cx="158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" name="Rectangle 288">
              <a:extLst>
                <a:ext uri="{FF2B5EF4-FFF2-40B4-BE49-F238E27FC236}">
                  <a16:creationId xmlns:a16="http://schemas.microsoft.com/office/drawing/2014/main" id="{C5435E4F-19BA-6EBB-98FF-AF067DD77C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0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3" name="Rectangle 289">
              <a:extLst>
                <a:ext uri="{FF2B5EF4-FFF2-40B4-BE49-F238E27FC236}">
                  <a16:creationId xmlns:a16="http://schemas.microsoft.com/office/drawing/2014/main" id="{8B52A0F5-525C-4397-0081-F6328A9560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4" name="Rectangle 290">
              <a:extLst>
                <a:ext uri="{FF2B5EF4-FFF2-40B4-BE49-F238E27FC236}">
                  <a16:creationId xmlns:a16="http://schemas.microsoft.com/office/drawing/2014/main" id="{74E8DCE3-1ECF-6066-2259-3AE3703D37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5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5" name="Rectangle 291">
              <a:extLst>
                <a:ext uri="{FF2B5EF4-FFF2-40B4-BE49-F238E27FC236}">
                  <a16:creationId xmlns:a16="http://schemas.microsoft.com/office/drawing/2014/main" id="{C8CC9310-77C5-9AAD-D721-2AFFF155A9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5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6" name="Rectangle 292">
              <a:extLst>
                <a:ext uri="{FF2B5EF4-FFF2-40B4-BE49-F238E27FC236}">
                  <a16:creationId xmlns:a16="http://schemas.microsoft.com/office/drawing/2014/main" id="{787EB73B-95B1-529B-E2CD-C40E1A4D74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5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7" name="Rectangle 293">
              <a:extLst>
                <a:ext uri="{FF2B5EF4-FFF2-40B4-BE49-F238E27FC236}">
                  <a16:creationId xmlns:a16="http://schemas.microsoft.com/office/drawing/2014/main" id="{4996D378-F998-A436-B938-A927085A3F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45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8" name="Rectangle 294">
              <a:extLst>
                <a:ext uri="{FF2B5EF4-FFF2-40B4-BE49-F238E27FC236}">
                  <a16:creationId xmlns:a16="http://schemas.microsoft.com/office/drawing/2014/main" id="{F03A5A59-F286-C5C8-73EB-71EF78127C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0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9" name="Rectangle 295">
              <a:extLst>
                <a:ext uri="{FF2B5EF4-FFF2-40B4-BE49-F238E27FC236}">
                  <a16:creationId xmlns:a16="http://schemas.microsoft.com/office/drawing/2014/main" id="{089EBBEC-82DC-FE05-24A0-E39FC839E7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0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0" name="Rectangle 296">
              <a:extLst>
                <a:ext uri="{FF2B5EF4-FFF2-40B4-BE49-F238E27FC236}">
                  <a16:creationId xmlns:a16="http://schemas.microsoft.com/office/drawing/2014/main" id="{3146CE81-A220-98AC-549C-96F3A0FC7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0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1" name="Rectangle 297">
              <a:extLst>
                <a:ext uri="{FF2B5EF4-FFF2-40B4-BE49-F238E27FC236}">
                  <a16:creationId xmlns:a16="http://schemas.microsoft.com/office/drawing/2014/main" id="{588FFA1F-0FB6-7014-960A-266065361B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9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2" name="Rectangle 298">
              <a:extLst>
                <a:ext uri="{FF2B5EF4-FFF2-40B4-BE49-F238E27FC236}">
                  <a16:creationId xmlns:a16="http://schemas.microsoft.com/office/drawing/2014/main" id="{10B38F3E-940A-81B9-AB28-93EB6FF49B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9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3" name="Rectangle 299">
              <a:extLst>
                <a:ext uri="{FF2B5EF4-FFF2-40B4-BE49-F238E27FC236}">
                  <a16:creationId xmlns:a16="http://schemas.microsoft.com/office/drawing/2014/main" id="{DEFF6EB8-7AA3-C0CD-2C5B-6D159FBFE8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4" y="3065"/>
              <a:ext cx="204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r>
                <a:rPr kumimoji="0" lang="ja-JP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≤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4" name="Rectangle 300">
              <a:extLst>
                <a:ext uri="{FF2B5EF4-FFF2-40B4-BE49-F238E27FC236}">
                  <a16:creationId xmlns:a16="http://schemas.microsoft.com/office/drawing/2014/main" id="{4694435A-63D3-57E7-EA3B-B52A0D83AD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627"/>
              <a:ext cx="62" cy="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5" name="Rectangle 301">
              <a:extLst>
                <a:ext uri="{FF2B5EF4-FFF2-40B4-BE49-F238E27FC236}">
                  <a16:creationId xmlns:a16="http://schemas.microsoft.com/office/drawing/2014/main" id="{DB1CEFB3-F2F3-FAFE-AAAA-0D19ED7A02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627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Rectangle 302">
              <a:extLst>
                <a:ext uri="{FF2B5EF4-FFF2-40B4-BE49-F238E27FC236}">
                  <a16:creationId xmlns:a16="http://schemas.microsoft.com/office/drawing/2014/main" id="{AD4D7F55-1318-0EF2-D595-DC3639736A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875"/>
              <a:ext cx="62" cy="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Rectangle 303">
              <a:extLst>
                <a:ext uri="{FF2B5EF4-FFF2-40B4-BE49-F238E27FC236}">
                  <a16:creationId xmlns:a16="http://schemas.microsoft.com/office/drawing/2014/main" id="{A469B9FA-A161-8358-2652-E9B83BFBAC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2" y="875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Line 307">
              <a:extLst>
                <a:ext uri="{FF2B5EF4-FFF2-40B4-BE49-F238E27FC236}">
                  <a16:creationId xmlns:a16="http://schemas.microsoft.com/office/drawing/2014/main" id="{744EE170-5EF5-BF1B-FCF7-E0FFD3518A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1" y="864"/>
              <a:ext cx="0" cy="206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Line 308">
              <a:extLst>
                <a:ext uri="{FF2B5EF4-FFF2-40B4-BE49-F238E27FC236}">
                  <a16:creationId xmlns:a16="http://schemas.microsoft.com/office/drawing/2014/main" id="{1247076A-F4FA-06EC-B980-5F37EA2901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93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Line 309">
              <a:extLst>
                <a:ext uri="{FF2B5EF4-FFF2-40B4-BE49-F238E27FC236}">
                  <a16:creationId xmlns:a16="http://schemas.microsoft.com/office/drawing/2014/main" id="{A6882E3E-6EE4-92B4-C1DC-E8B0C3770D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41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Line 310">
              <a:extLst>
                <a:ext uri="{FF2B5EF4-FFF2-40B4-BE49-F238E27FC236}">
                  <a16:creationId xmlns:a16="http://schemas.microsoft.com/office/drawing/2014/main" id="{649663E5-1370-5C4C-67CC-BEAE2F70E5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898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5" name="Line 311">
              <a:extLst>
                <a:ext uri="{FF2B5EF4-FFF2-40B4-BE49-F238E27FC236}">
                  <a16:creationId xmlns:a16="http://schemas.microsoft.com/office/drawing/2014/main" id="{D9AFA3F4-B6B7-B825-A7EF-8C7FD14233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384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Line 312">
              <a:extLst>
                <a:ext uri="{FF2B5EF4-FFF2-40B4-BE49-F238E27FC236}">
                  <a16:creationId xmlns:a16="http://schemas.microsoft.com/office/drawing/2014/main" id="{E7847F31-B818-6FF0-06F1-EBF3D6D7D4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864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Rectangle 313">
              <a:extLst>
                <a:ext uri="{FF2B5EF4-FFF2-40B4-BE49-F238E27FC236}">
                  <a16:creationId xmlns:a16="http://schemas.microsoft.com/office/drawing/2014/main" id="{1C80B19E-6D29-3BFA-F35E-496FAC33D7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" y="2896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8" name="Rectangle 314">
              <a:extLst>
                <a:ext uri="{FF2B5EF4-FFF2-40B4-BE49-F238E27FC236}">
                  <a16:creationId xmlns:a16="http://schemas.microsoft.com/office/drawing/2014/main" id="{8730607A-FDA8-3F82-C5F4-BFFA85CFA8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2381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9" name="Rectangle 315">
              <a:extLst>
                <a:ext uri="{FF2B5EF4-FFF2-40B4-BE49-F238E27FC236}">
                  <a16:creationId xmlns:a16="http://schemas.microsoft.com/office/drawing/2014/main" id="{BD0D34EE-D8EA-3793-C164-E4F88A5546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867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0" name="Rectangle 316">
              <a:extLst>
                <a:ext uri="{FF2B5EF4-FFF2-40B4-BE49-F238E27FC236}">
                  <a16:creationId xmlns:a16="http://schemas.microsoft.com/office/drawing/2014/main" id="{498B0D55-ACBF-9609-360F-E819C19AF2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348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1" name="Rectangle 317">
              <a:extLst>
                <a:ext uri="{FF2B5EF4-FFF2-40B4-BE49-F238E27FC236}">
                  <a16:creationId xmlns:a16="http://schemas.microsoft.com/office/drawing/2014/main" id="{4146CC02-E839-A8E2-5247-ECD82BC0AD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833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334" name="Group 320">
            <a:extLst>
              <a:ext uri="{FF2B5EF4-FFF2-40B4-BE49-F238E27FC236}">
                <a16:creationId xmlns:a16="http://schemas.microsoft.com/office/drawing/2014/main" id="{B3C42E1E-E47A-BA1D-0228-CAD1EF16DB9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576871" y="4114878"/>
            <a:ext cx="2433626" cy="2397682"/>
            <a:chOff x="1849" y="302"/>
            <a:chExt cx="2979" cy="2935"/>
          </a:xfrm>
        </p:grpSpPr>
        <p:sp>
          <p:nvSpPr>
            <p:cNvPr id="336" name="Rectangle 321">
              <a:extLst>
                <a:ext uri="{FF2B5EF4-FFF2-40B4-BE49-F238E27FC236}">
                  <a16:creationId xmlns:a16="http://schemas.microsoft.com/office/drawing/2014/main" id="{CF42F1DB-9DE0-8761-5118-5828018C33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932"/>
              <a:ext cx="62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7" name="Rectangle 322">
              <a:extLst>
                <a:ext uri="{FF2B5EF4-FFF2-40B4-BE49-F238E27FC236}">
                  <a16:creationId xmlns:a16="http://schemas.microsoft.com/office/drawing/2014/main" id="{AE26FCA4-ED1E-9FDA-6D1D-D1B0EAD0DB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2932"/>
              <a:ext cx="62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8" name="Rectangle 323">
              <a:extLst>
                <a:ext uri="{FF2B5EF4-FFF2-40B4-BE49-F238E27FC236}">
                  <a16:creationId xmlns:a16="http://schemas.microsoft.com/office/drawing/2014/main" id="{E944898F-3A0B-965A-CADD-5751CD3822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2510"/>
              <a:ext cx="67" cy="42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9" name="Rectangle 324">
              <a:extLst>
                <a:ext uri="{FF2B5EF4-FFF2-40B4-BE49-F238E27FC236}">
                  <a16:creationId xmlns:a16="http://schemas.microsoft.com/office/drawing/2014/main" id="{A815ED4F-4FDD-7263-93A5-ED8C087755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" y="2510"/>
              <a:ext cx="67" cy="42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Rectangle 325">
              <a:extLst>
                <a:ext uri="{FF2B5EF4-FFF2-40B4-BE49-F238E27FC236}">
                  <a16:creationId xmlns:a16="http://schemas.microsoft.com/office/drawing/2014/main" id="{09A159BB-7628-12CD-60A0-623C0D31DD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" y="2870"/>
              <a:ext cx="66" cy="6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Rectangle 326">
              <a:extLst>
                <a:ext uri="{FF2B5EF4-FFF2-40B4-BE49-F238E27FC236}">
                  <a16:creationId xmlns:a16="http://schemas.microsoft.com/office/drawing/2014/main" id="{F859D728-43E8-1E7A-0DEB-E997522770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" y="2870"/>
              <a:ext cx="66" cy="6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Rectangle 327">
              <a:extLst>
                <a:ext uri="{FF2B5EF4-FFF2-40B4-BE49-F238E27FC236}">
                  <a16:creationId xmlns:a16="http://schemas.microsoft.com/office/drawing/2014/main" id="{669C1C38-DA4D-F39C-4387-6C8A6398FB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0" y="2510"/>
              <a:ext cx="67" cy="42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Rectangle 328">
              <a:extLst>
                <a:ext uri="{FF2B5EF4-FFF2-40B4-BE49-F238E27FC236}">
                  <a16:creationId xmlns:a16="http://schemas.microsoft.com/office/drawing/2014/main" id="{85651B98-F526-97F6-EC8F-ADB8DA785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0" y="2510"/>
              <a:ext cx="67" cy="42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4" name="Rectangle 329">
              <a:extLst>
                <a:ext uri="{FF2B5EF4-FFF2-40B4-BE49-F238E27FC236}">
                  <a16:creationId xmlns:a16="http://schemas.microsoft.com/office/drawing/2014/main" id="{B22A3A4A-6B85-FD8E-3CA5-61E0BE5627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3" y="2808"/>
              <a:ext cx="62" cy="12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5" name="Rectangle 330">
              <a:extLst>
                <a:ext uri="{FF2B5EF4-FFF2-40B4-BE49-F238E27FC236}">
                  <a16:creationId xmlns:a16="http://schemas.microsoft.com/office/drawing/2014/main" id="{D7E40B26-501F-DB3E-7DB5-52CD562BAA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3" y="2808"/>
              <a:ext cx="62" cy="12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Rectangle 331">
              <a:extLst>
                <a:ext uri="{FF2B5EF4-FFF2-40B4-BE49-F238E27FC236}">
                  <a16:creationId xmlns:a16="http://schemas.microsoft.com/office/drawing/2014/main" id="{0803ADC0-773F-CB79-7C07-B49C4EC8D1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5" y="2510"/>
              <a:ext cx="67" cy="42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Rectangle 332">
              <a:extLst>
                <a:ext uri="{FF2B5EF4-FFF2-40B4-BE49-F238E27FC236}">
                  <a16:creationId xmlns:a16="http://schemas.microsoft.com/office/drawing/2014/main" id="{8BC3FF1F-4A41-1428-CF3B-C390A7D21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5" y="2510"/>
              <a:ext cx="67" cy="42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Rectangle 333">
              <a:extLst>
                <a:ext uri="{FF2B5EF4-FFF2-40B4-BE49-F238E27FC236}">
                  <a16:creationId xmlns:a16="http://schemas.microsoft.com/office/drawing/2014/main" id="{5028205D-C454-2A57-2911-22248CE8B0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7" y="2932"/>
              <a:ext cx="67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Rectangle 334">
              <a:extLst>
                <a:ext uri="{FF2B5EF4-FFF2-40B4-BE49-F238E27FC236}">
                  <a16:creationId xmlns:a16="http://schemas.microsoft.com/office/drawing/2014/main" id="{96C887BC-8272-F948-2869-79EFDA1BF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7" y="2932"/>
              <a:ext cx="67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Rectangle 335">
              <a:extLst>
                <a:ext uri="{FF2B5EF4-FFF2-40B4-BE49-F238E27FC236}">
                  <a16:creationId xmlns:a16="http://schemas.microsoft.com/office/drawing/2014/main" id="{E2183D05-F9BB-C5B3-CF26-50F74271BB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" y="1965"/>
              <a:ext cx="67" cy="96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Rectangle 336">
              <a:extLst>
                <a:ext uri="{FF2B5EF4-FFF2-40B4-BE49-F238E27FC236}">
                  <a16:creationId xmlns:a16="http://schemas.microsoft.com/office/drawing/2014/main" id="{212D9D23-9454-E6AB-1AF5-A6FF09B14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4" y="1965"/>
              <a:ext cx="67" cy="96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Rectangle 337">
              <a:extLst>
                <a:ext uri="{FF2B5EF4-FFF2-40B4-BE49-F238E27FC236}">
                  <a16:creationId xmlns:a16="http://schemas.microsoft.com/office/drawing/2014/main" id="{E799C74E-6082-384E-006A-A407C2C9E9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7" y="2448"/>
              <a:ext cx="61" cy="48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Rectangle 338">
              <a:extLst>
                <a:ext uri="{FF2B5EF4-FFF2-40B4-BE49-F238E27FC236}">
                  <a16:creationId xmlns:a16="http://schemas.microsoft.com/office/drawing/2014/main" id="{465AE88C-A882-6CC5-BF0B-C6F3C1AED8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7" y="2448"/>
              <a:ext cx="61" cy="48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Rectangle 339">
              <a:extLst>
                <a:ext uri="{FF2B5EF4-FFF2-40B4-BE49-F238E27FC236}">
                  <a16:creationId xmlns:a16="http://schemas.microsoft.com/office/drawing/2014/main" id="{85089C73-88EA-DD93-D016-4D64C3D702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" y="1785"/>
              <a:ext cx="67" cy="11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Rectangle 340">
              <a:extLst>
                <a:ext uri="{FF2B5EF4-FFF2-40B4-BE49-F238E27FC236}">
                  <a16:creationId xmlns:a16="http://schemas.microsoft.com/office/drawing/2014/main" id="{EA1ED9BB-3D96-A7AA-2D86-2A9E6BE385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8" y="1785"/>
              <a:ext cx="67" cy="11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Rectangle 341">
              <a:extLst>
                <a:ext uri="{FF2B5EF4-FFF2-40B4-BE49-F238E27FC236}">
                  <a16:creationId xmlns:a16="http://schemas.microsoft.com/office/drawing/2014/main" id="{CC8B9087-DDF1-CED2-5D76-DD0A25F36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" y="1965"/>
              <a:ext cx="67" cy="96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Rectangle 342">
              <a:extLst>
                <a:ext uri="{FF2B5EF4-FFF2-40B4-BE49-F238E27FC236}">
                  <a16:creationId xmlns:a16="http://schemas.microsoft.com/office/drawing/2014/main" id="{E38FBEDF-3E98-571D-61B2-BE235DB87B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" y="1965"/>
              <a:ext cx="67" cy="96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8" name="Rectangle 343">
              <a:extLst>
                <a:ext uri="{FF2B5EF4-FFF2-40B4-BE49-F238E27FC236}">
                  <a16:creationId xmlns:a16="http://schemas.microsoft.com/office/drawing/2014/main" id="{C189AEB3-AF46-DE95-D67A-07D7D259F3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8" y="1785"/>
              <a:ext cx="62" cy="11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Rectangle 344">
              <a:extLst>
                <a:ext uri="{FF2B5EF4-FFF2-40B4-BE49-F238E27FC236}">
                  <a16:creationId xmlns:a16="http://schemas.microsoft.com/office/drawing/2014/main" id="{82FDA9DA-3A48-F8E1-C1FE-0DBD07E711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8" y="1785"/>
              <a:ext cx="62" cy="11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0" name="Rectangle 345">
              <a:extLst>
                <a:ext uri="{FF2B5EF4-FFF2-40B4-BE49-F238E27FC236}">
                  <a16:creationId xmlns:a16="http://schemas.microsoft.com/office/drawing/2014/main" id="{C0F7604A-0897-A0E7-E5AA-D741CC853E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0" y="1785"/>
              <a:ext cx="62" cy="11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1" name="Rectangle 346">
              <a:extLst>
                <a:ext uri="{FF2B5EF4-FFF2-40B4-BE49-F238E27FC236}">
                  <a16:creationId xmlns:a16="http://schemas.microsoft.com/office/drawing/2014/main" id="{80A83A10-2D80-84ED-80EA-EB601E357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0" y="1785"/>
              <a:ext cx="62" cy="11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Rectangle 347">
              <a:extLst>
                <a:ext uri="{FF2B5EF4-FFF2-40B4-BE49-F238E27FC236}">
                  <a16:creationId xmlns:a16="http://schemas.microsoft.com/office/drawing/2014/main" id="{B4B81DB4-7E1C-9E4D-554F-FD37B9BF28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2" y="463"/>
              <a:ext cx="67" cy="2469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Rectangle 348">
              <a:extLst>
                <a:ext uri="{FF2B5EF4-FFF2-40B4-BE49-F238E27FC236}">
                  <a16:creationId xmlns:a16="http://schemas.microsoft.com/office/drawing/2014/main" id="{192EC2A9-B68B-D6E3-C596-EE1F3A8440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2" y="463"/>
              <a:ext cx="67" cy="246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Rectangle 349">
              <a:extLst>
                <a:ext uri="{FF2B5EF4-FFF2-40B4-BE49-F238E27FC236}">
                  <a16:creationId xmlns:a16="http://schemas.microsoft.com/office/drawing/2014/main" id="{9A1DC7C7-EBE9-98A0-A8EB-FA67B31B56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" y="1965"/>
              <a:ext cx="67" cy="96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Rectangle 350">
              <a:extLst>
                <a:ext uri="{FF2B5EF4-FFF2-40B4-BE49-F238E27FC236}">
                  <a16:creationId xmlns:a16="http://schemas.microsoft.com/office/drawing/2014/main" id="{9BD5B7B9-0B61-9EBE-2ED5-37016C2F6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" y="1965"/>
              <a:ext cx="67" cy="96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Rectangle 351">
              <a:extLst>
                <a:ext uri="{FF2B5EF4-FFF2-40B4-BE49-F238E27FC236}">
                  <a16:creationId xmlns:a16="http://schemas.microsoft.com/office/drawing/2014/main" id="{5D2A3A48-89E5-2CE3-2491-23EF5AC98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" y="401"/>
              <a:ext cx="61" cy="253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" name="Rectangle 352">
              <a:extLst>
                <a:ext uri="{FF2B5EF4-FFF2-40B4-BE49-F238E27FC236}">
                  <a16:creationId xmlns:a16="http://schemas.microsoft.com/office/drawing/2014/main" id="{6B6E64E7-E69B-4AD6-16B7-DA2BC4CDDA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" y="401"/>
              <a:ext cx="61" cy="253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Rectangle 353">
              <a:extLst>
                <a:ext uri="{FF2B5EF4-FFF2-40B4-BE49-F238E27FC236}">
                  <a16:creationId xmlns:a16="http://schemas.microsoft.com/office/drawing/2014/main" id="{5E0D5C25-1201-3797-F280-6659398106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2330"/>
              <a:ext cx="62" cy="60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Rectangle 354">
              <a:extLst>
                <a:ext uri="{FF2B5EF4-FFF2-40B4-BE49-F238E27FC236}">
                  <a16:creationId xmlns:a16="http://schemas.microsoft.com/office/drawing/2014/main" id="{E2EC6AE8-4EC3-9603-D14E-C5DCA7B252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4" y="2330"/>
              <a:ext cx="62" cy="60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Rectangle 355">
              <a:extLst>
                <a:ext uri="{FF2B5EF4-FFF2-40B4-BE49-F238E27FC236}">
                  <a16:creationId xmlns:a16="http://schemas.microsoft.com/office/drawing/2014/main" id="{50E6484A-515C-89D5-163F-7B8E315B52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946"/>
              <a:ext cx="67" cy="1986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" name="Rectangle 356">
              <a:extLst>
                <a:ext uri="{FF2B5EF4-FFF2-40B4-BE49-F238E27FC236}">
                  <a16:creationId xmlns:a16="http://schemas.microsoft.com/office/drawing/2014/main" id="{BD50CED4-37A3-3532-CC3D-D14B205BD3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6" y="946"/>
              <a:ext cx="67" cy="1986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" name="Rectangle 357">
              <a:extLst>
                <a:ext uri="{FF2B5EF4-FFF2-40B4-BE49-F238E27FC236}">
                  <a16:creationId xmlns:a16="http://schemas.microsoft.com/office/drawing/2014/main" id="{C21F644D-6B9E-7C5C-0E48-24031D301E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8" y="1965"/>
              <a:ext cx="67" cy="96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" name="Rectangle 358">
              <a:extLst>
                <a:ext uri="{FF2B5EF4-FFF2-40B4-BE49-F238E27FC236}">
                  <a16:creationId xmlns:a16="http://schemas.microsoft.com/office/drawing/2014/main" id="{C9AFBCD1-20B7-CA1F-5447-47E384CEE4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8" y="1965"/>
              <a:ext cx="67" cy="96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" name="Rectangle 359">
              <a:extLst>
                <a:ext uri="{FF2B5EF4-FFF2-40B4-BE49-F238E27FC236}">
                  <a16:creationId xmlns:a16="http://schemas.microsoft.com/office/drawing/2014/main" id="{EAF49341-75D3-06D5-9BBD-4848238F5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5" y="1785"/>
              <a:ext cx="62" cy="11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" name="Rectangle 360">
              <a:extLst>
                <a:ext uri="{FF2B5EF4-FFF2-40B4-BE49-F238E27FC236}">
                  <a16:creationId xmlns:a16="http://schemas.microsoft.com/office/drawing/2014/main" id="{AA3A4839-9EB9-8A3C-4327-C63B5BDE42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5" y="1785"/>
              <a:ext cx="62" cy="11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" name="Rectangle 361">
              <a:extLst>
                <a:ext uri="{FF2B5EF4-FFF2-40B4-BE49-F238E27FC236}">
                  <a16:creationId xmlns:a16="http://schemas.microsoft.com/office/drawing/2014/main" id="{1FA622CF-9D6E-067D-DBBC-10CBC67417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3" y="2448"/>
              <a:ext cx="67" cy="484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Rectangle 362">
              <a:extLst>
                <a:ext uri="{FF2B5EF4-FFF2-40B4-BE49-F238E27FC236}">
                  <a16:creationId xmlns:a16="http://schemas.microsoft.com/office/drawing/2014/main" id="{50BF991D-8143-0B68-A59E-83EF470DF3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3" y="2448"/>
              <a:ext cx="67" cy="48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" name="Rectangle 363">
              <a:extLst>
                <a:ext uri="{FF2B5EF4-FFF2-40B4-BE49-F238E27FC236}">
                  <a16:creationId xmlns:a16="http://schemas.microsoft.com/office/drawing/2014/main" id="{88EF8696-0480-BF04-CEBB-C79B686F2F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0" y="1965"/>
              <a:ext cx="66" cy="96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" name="Rectangle 364">
              <a:extLst>
                <a:ext uri="{FF2B5EF4-FFF2-40B4-BE49-F238E27FC236}">
                  <a16:creationId xmlns:a16="http://schemas.microsoft.com/office/drawing/2014/main" id="{36FB41BE-F643-CBD6-5704-6B65CE296D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0" y="1965"/>
              <a:ext cx="66" cy="96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" name="Rectangle 365">
              <a:extLst>
                <a:ext uri="{FF2B5EF4-FFF2-40B4-BE49-F238E27FC236}">
                  <a16:creationId xmlns:a16="http://schemas.microsoft.com/office/drawing/2014/main" id="{E7EC4473-C4EC-A79A-CE2C-881C65922F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2" y="2510"/>
              <a:ext cx="67" cy="42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" name="Rectangle 366">
              <a:extLst>
                <a:ext uri="{FF2B5EF4-FFF2-40B4-BE49-F238E27FC236}">
                  <a16:creationId xmlns:a16="http://schemas.microsoft.com/office/drawing/2014/main" id="{18A24192-C956-477B-01FA-64B1355622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2" y="2510"/>
              <a:ext cx="67" cy="42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" name="Rectangle 367">
              <a:extLst>
                <a:ext uri="{FF2B5EF4-FFF2-40B4-BE49-F238E27FC236}">
                  <a16:creationId xmlns:a16="http://schemas.microsoft.com/office/drawing/2014/main" id="{9C1B2523-50BD-F2D5-8DE0-233816576C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2690"/>
              <a:ext cx="62" cy="242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" name="Rectangle 368">
              <a:extLst>
                <a:ext uri="{FF2B5EF4-FFF2-40B4-BE49-F238E27FC236}">
                  <a16:creationId xmlns:a16="http://schemas.microsoft.com/office/drawing/2014/main" id="{909FC611-0E62-C441-7C21-ECB7B4C420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2690"/>
              <a:ext cx="62" cy="24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" name="Rectangle 369">
              <a:extLst>
                <a:ext uri="{FF2B5EF4-FFF2-40B4-BE49-F238E27FC236}">
                  <a16:creationId xmlns:a16="http://schemas.microsoft.com/office/drawing/2014/main" id="{2147510C-52BE-0EDC-08BF-5C416B6F4E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6" y="2870"/>
              <a:ext cx="67" cy="6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" name="Rectangle 370">
              <a:extLst>
                <a:ext uri="{FF2B5EF4-FFF2-40B4-BE49-F238E27FC236}">
                  <a16:creationId xmlns:a16="http://schemas.microsoft.com/office/drawing/2014/main" id="{26BC24CE-1EBD-6418-2A17-9DAB83F47B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6" y="2870"/>
              <a:ext cx="67" cy="6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" name="Rectangle 371">
              <a:extLst>
                <a:ext uri="{FF2B5EF4-FFF2-40B4-BE49-F238E27FC236}">
                  <a16:creationId xmlns:a16="http://schemas.microsoft.com/office/drawing/2014/main" id="{3F1ADDA9-8754-1006-F226-92E4B4210D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3" y="2752"/>
              <a:ext cx="67" cy="18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" name="Rectangle 372">
              <a:extLst>
                <a:ext uri="{FF2B5EF4-FFF2-40B4-BE49-F238E27FC236}">
                  <a16:creationId xmlns:a16="http://schemas.microsoft.com/office/drawing/2014/main" id="{6B4188A1-0609-487C-A1AE-2276CA7A61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3" y="2752"/>
              <a:ext cx="67" cy="18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8" name="Rectangle 373">
              <a:extLst>
                <a:ext uri="{FF2B5EF4-FFF2-40B4-BE49-F238E27FC236}">
                  <a16:creationId xmlns:a16="http://schemas.microsoft.com/office/drawing/2014/main" id="{6EC79875-6FCC-381D-6EB4-631437883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6" y="2870"/>
              <a:ext cx="67" cy="6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9" name="Rectangle 374">
              <a:extLst>
                <a:ext uri="{FF2B5EF4-FFF2-40B4-BE49-F238E27FC236}">
                  <a16:creationId xmlns:a16="http://schemas.microsoft.com/office/drawing/2014/main" id="{2A07D5D3-493A-3E83-7EE7-8382E66EF9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6" y="2870"/>
              <a:ext cx="67" cy="6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0" name="Rectangle 375">
              <a:extLst>
                <a:ext uri="{FF2B5EF4-FFF2-40B4-BE49-F238E27FC236}">
                  <a16:creationId xmlns:a16="http://schemas.microsoft.com/office/drawing/2014/main" id="{21E2DEF9-6E48-6B2F-0020-CABA78B4A9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3" y="2752"/>
              <a:ext cx="61" cy="180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1" name="Rectangle 376">
              <a:extLst>
                <a:ext uri="{FF2B5EF4-FFF2-40B4-BE49-F238E27FC236}">
                  <a16:creationId xmlns:a16="http://schemas.microsoft.com/office/drawing/2014/main" id="{A711008A-0E1F-9787-98AD-B05BB299B5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3" y="2752"/>
              <a:ext cx="61" cy="18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2" name="Rectangle 377">
              <a:extLst>
                <a:ext uri="{FF2B5EF4-FFF2-40B4-BE49-F238E27FC236}">
                  <a16:creationId xmlns:a16="http://schemas.microsoft.com/office/drawing/2014/main" id="{D36D2024-913F-CD56-8599-C577C13B0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0" y="2932"/>
              <a:ext cx="67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" name="Rectangle 378">
              <a:extLst>
                <a:ext uri="{FF2B5EF4-FFF2-40B4-BE49-F238E27FC236}">
                  <a16:creationId xmlns:a16="http://schemas.microsoft.com/office/drawing/2014/main" id="{400D5E43-3DBA-4054-E7A0-5FC46B5C39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0" y="2932"/>
              <a:ext cx="67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4" name="Rectangle 379">
              <a:extLst>
                <a:ext uri="{FF2B5EF4-FFF2-40B4-BE49-F238E27FC236}">
                  <a16:creationId xmlns:a16="http://schemas.microsoft.com/office/drawing/2014/main" id="{B476EA1F-300C-034B-24B1-A08F4388A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7" y="2808"/>
              <a:ext cx="67" cy="124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5" name="Rectangle 380">
              <a:extLst>
                <a:ext uri="{FF2B5EF4-FFF2-40B4-BE49-F238E27FC236}">
                  <a16:creationId xmlns:a16="http://schemas.microsoft.com/office/drawing/2014/main" id="{308BFC54-A38A-CBD5-513D-E831841A7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7" y="2808"/>
              <a:ext cx="67" cy="12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6" name="Rectangle 381">
              <a:extLst>
                <a:ext uri="{FF2B5EF4-FFF2-40B4-BE49-F238E27FC236}">
                  <a16:creationId xmlns:a16="http://schemas.microsoft.com/office/drawing/2014/main" id="{F4A503F0-CF99-565A-F526-8495A22508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0" y="2932"/>
              <a:ext cx="61" cy="1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" name="Rectangle 382">
              <a:extLst>
                <a:ext uri="{FF2B5EF4-FFF2-40B4-BE49-F238E27FC236}">
                  <a16:creationId xmlns:a16="http://schemas.microsoft.com/office/drawing/2014/main" id="{16BE9A90-824A-FE0C-E331-1885A8A40D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0" y="2932"/>
              <a:ext cx="61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" name="Rectangle 383">
              <a:extLst>
                <a:ext uri="{FF2B5EF4-FFF2-40B4-BE49-F238E27FC236}">
                  <a16:creationId xmlns:a16="http://schemas.microsoft.com/office/drawing/2014/main" id="{EDDBB49D-F337-E4FC-262A-5651BB9F0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1" y="2808"/>
              <a:ext cx="67" cy="124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" name="Rectangle 384">
              <a:extLst>
                <a:ext uri="{FF2B5EF4-FFF2-40B4-BE49-F238E27FC236}">
                  <a16:creationId xmlns:a16="http://schemas.microsoft.com/office/drawing/2014/main" id="{44C3725D-E885-ABC9-B264-9E082CE116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1" y="2808"/>
              <a:ext cx="67" cy="12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0" name="Rectangle 385">
              <a:extLst>
                <a:ext uri="{FF2B5EF4-FFF2-40B4-BE49-F238E27FC236}">
                  <a16:creationId xmlns:a16="http://schemas.microsoft.com/office/drawing/2014/main" id="{6DF522EC-6339-A12D-FE72-B397F2B82D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4" y="2870"/>
              <a:ext cx="67" cy="62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1" name="Rectangle 386">
              <a:extLst>
                <a:ext uri="{FF2B5EF4-FFF2-40B4-BE49-F238E27FC236}">
                  <a16:creationId xmlns:a16="http://schemas.microsoft.com/office/drawing/2014/main" id="{8A8140E1-4909-2F81-817E-3D849A9136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94" y="2870"/>
              <a:ext cx="67" cy="6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2" name="Rectangle 387">
              <a:extLst>
                <a:ext uri="{FF2B5EF4-FFF2-40B4-BE49-F238E27FC236}">
                  <a16:creationId xmlns:a16="http://schemas.microsoft.com/office/drawing/2014/main" id="{FC8C91E4-B0F4-55F8-EBD7-4DC0F02994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1" y="2932"/>
              <a:ext cx="67" cy="1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3" name="Rectangle 388">
              <a:extLst>
                <a:ext uri="{FF2B5EF4-FFF2-40B4-BE49-F238E27FC236}">
                  <a16:creationId xmlns:a16="http://schemas.microsoft.com/office/drawing/2014/main" id="{26C550EC-790F-949E-8AA9-5959AE9B15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1" y="2932"/>
              <a:ext cx="67" cy="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4" name="Line 389">
              <a:extLst>
                <a:ext uri="{FF2B5EF4-FFF2-40B4-BE49-F238E27FC236}">
                  <a16:creationId xmlns:a16="http://schemas.microsoft.com/office/drawing/2014/main" id="{EA3E5DD1-018F-DD11-3B9B-2A8BC349F1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1" y="2957"/>
              <a:ext cx="2510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5" name="Line 390">
              <a:extLst>
                <a:ext uri="{FF2B5EF4-FFF2-40B4-BE49-F238E27FC236}">
                  <a16:creationId xmlns:a16="http://schemas.microsoft.com/office/drawing/2014/main" id="{10B077AB-7CE0-2D15-2CBC-05F470201D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6" name="Line 391">
              <a:extLst>
                <a:ext uri="{FF2B5EF4-FFF2-40B4-BE49-F238E27FC236}">
                  <a16:creationId xmlns:a16="http://schemas.microsoft.com/office/drawing/2014/main" id="{9102165F-2062-ECC1-87E4-64806CABBA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0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" name="Line 392">
              <a:extLst>
                <a:ext uri="{FF2B5EF4-FFF2-40B4-BE49-F238E27FC236}">
                  <a16:creationId xmlns:a16="http://schemas.microsoft.com/office/drawing/2014/main" id="{E294645F-C0FC-5B50-3540-4B0A1CFBEE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5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" name="Line 393">
              <a:extLst>
                <a:ext uri="{FF2B5EF4-FFF2-40B4-BE49-F238E27FC236}">
                  <a16:creationId xmlns:a16="http://schemas.microsoft.com/office/drawing/2014/main" id="{F3151896-A581-E869-0103-795A26F149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4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9" name="Line 394">
              <a:extLst>
                <a:ext uri="{FF2B5EF4-FFF2-40B4-BE49-F238E27FC236}">
                  <a16:creationId xmlns:a16="http://schemas.microsoft.com/office/drawing/2014/main" id="{0596C06B-6A5D-8A0A-5ECB-569F31F47E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8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0" name="Line 395">
              <a:extLst>
                <a:ext uri="{FF2B5EF4-FFF2-40B4-BE49-F238E27FC236}">
                  <a16:creationId xmlns:a16="http://schemas.microsoft.com/office/drawing/2014/main" id="{6DB6F7FB-06B6-8F46-9797-9B70711843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8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1" name="Line 396">
              <a:extLst>
                <a:ext uri="{FF2B5EF4-FFF2-40B4-BE49-F238E27FC236}">
                  <a16:creationId xmlns:a16="http://schemas.microsoft.com/office/drawing/2014/main" id="{EB9D8D1A-1027-C374-AC3A-C4F614A480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2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2" name="Line 397">
              <a:extLst>
                <a:ext uri="{FF2B5EF4-FFF2-40B4-BE49-F238E27FC236}">
                  <a16:creationId xmlns:a16="http://schemas.microsoft.com/office/drawing/2014/main" id="{0B758C97-2A3E-5128-83E3-3C71D15F3D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52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3" name="Line 398">
              <a:extLst>
                <a:ext uri="{FF2B5EF4-FFF2-40B4-BE49-F238E27FC236}">
                  <a16:creationId xmlns:a16="http://schemas.microsoft.com/office/drawing/2014/main" id="{046E5017-D523-2107-605E-2B2002080B2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6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4" name="Line 399">
              <a:extLst>
                <a:ext uri="{FF2B5EF4-FFF2-40B4-BE49-F238E27FC236}">
                  <a16:creationId xmlns:a16="http://schemas.microsoft.com/office/drawing/2014/main" id="{BBD10B7E-DE3C-8C3E-8392-FEA1113129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5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5" name="Line 400">
              <a:extLst>
                <a:ext uri="{FF2B5EF4-FFF2-40B4-BE49-F238E27FC236}">
                  <a16:creationId xmlns:a16="http://schemas.microsoft.com/office/drawing/2014/main" id="{3EE306E1-3046-6608-B277-478A54715B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0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6" name="Line 401">
              <a:extLst>
                <a:ext uri="{FF2B5EF4-FFF2-40B4-BE49-F238E27FC236}">
                  <a16:creationId xmlns:a16="http://schemas.microsoft.com/office/drawing/2014/main" id="{6D5F08B9-E30D-48A0-7AFE-2EE09662B5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9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7" name="Line 402">
              <a:extLst>
                <a:ext uri="{FF2B5EF4-FFF2-40B4-BE49-F238E27FC236}">
                  <a16:creationId xmlns:a16="http://schemas.microsoft.com/office/drawing/2014/main" id="{FD2BB6D3-8B65-989F-5C19-BAF4718451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33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8" name="Line 403">
              <a:extLst>
                <a:ext uri="{FF2B5EF4-FFF2-40B4-BE49-F238E27FC236}">
                  <a16:creationId xmlns:a16="http://schemas.microsoft.com/office/drawing/2014/main" id="{09CF0965-B113-332C-DA3A-59B44DD595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3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9" name="Line 404">
              <a:extLst>
                <a:ext uri="{FF2B5EF4-FFF2-40B4-BE49-F238E27FC236}">
                  <a16:creationId xmlns:a16="http://schemas.microsoft.com/office/drawing/2014/main" id="{26AC8018-3ED2-178F-7565-26D050CA12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47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0" name="Line 405">
              <a:extLst>
                <a:ext uri="{FF2B5EF4-FFF2-40B4-BE49-F238E27FC236}">
                  <a16:creationId xmlns:a16="http://schemas.microsoft.com/office/drawing/2014/main" id="{ADB566FE-96CC-373C-308D-56E6980F96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1" name="Line 406">
              <a:extLst>
                <a:ext uri="{FF2B5EF4-FFF2-40B4-BE49-F238E27FC236}">
                  <a16:creationId xmlns:a16="http://schemas.microsoft.com/office/drawing/2014/main" id="{FDD6D130-0087-173B-754C-90C005ED77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61" y="2957"/>
              <a:ext cx="0" cy="4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2" name="Rectangle 407">
              <a:extLst>
                <a:ext uri="{FF2B5EF4-FFF2-40B4-BE49-F238E27FC236}">
                  <a16:creationId xmlns:a16="http://schemas.microsoft.com/office/drawing/2014/main" id="{C45F5C76-813A-5A49-DD5E-5C0A040A89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2" y="3065"/>
              <a:ext cx="284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≤</a:t>
              </a: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2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3" name="Rectangle 408">
              <a:extLst>
                <a:ext uri="{FF2B5EF4-FFF2-40B4-BE49-F238E27FC236}">
                  <a16:creationId xmlns:a16="http://schemas.microsoft.com/office/drawing/2014/main" id="{98FD16CB-0D21-0952-AC3B-1960DA568A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9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4" name="Rectangle 409">
              <a:extLst>
                <a:ext uri="{FF2B5EF4-FFF2-40B4-BE49-F238E27FC236}">
                  <a16:creationId xmlns:a16="http://schemas.microsoft.com/office/drawing/2014/main" id="{41D561AA-AA58-5D2A-D581-882BD438A9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8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5" name="Rectangle 410">
              <a:extLst>
                <a:ext uri="{FF2B5EF4-FFF2-40B4-BE49-F238E27FC236}">
                  <a16:creationId xmlns:a16="http://schemas.microsoft.com/office/drawing/2014/main" id="{F30F32D4-AE45-591D-9ECF-5FA9C91986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2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6" name="Rectangle 411">
              <a:extLst>
                <a:ext uri="{FF2B5EF4-FFF2-40B4-BE49-F238E27FC236}">
                  <a16:creationId xmlns:a16="http://schemas.microsoft.com/office/drawing/2014/main" id="{8DBEA7A8-46B2-BB82-EE99-5484D6A32E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2" y="3065"/>
              <a:ext cx="11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7" name="Rectangle 412">
              <a:extLst>
                <a:ext uri="{FF2B5EF4-FFF2-40B4-BE49-F238E27FC236}">
                  <a16:creationId xmlns:a16="http://schemas.microsoft.com/office/drawing/2014/main" id="{C39B54F5-37BC-6816-DE30-3E4F8CE24E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1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8" name="Rectangle 413">
              <a:extLst>
                <a:ext uri="{FF2B5EF4-FFF2-40B4-BE49-F238E27FC236}">
                  <a16:creationId xmlns:a16="http://schemas.microsoft.com/office/drawing/2014/main" id="{39BA7731-ED24-9A79-041E-461BDE09C6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1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9" name="Rectangle 414">
              <a:extLst>
                <a:ext uri="{FF2B5EF4-FFF2-40B4-BE49-F238E27FC236}">
                  <a16:creationId xmlns:a16="http://schemas.microsoft.com/office/drawing/2014/main" id="{2A798AA0-B9BE-1A20-A7A7-A3523234A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5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0" name="Rectangle 415">
              <a:extLst>
                <a:ext uri="{FF2B5EF4-FFF2-40B4-BE49-F238E27FC236}">
                  <a16:creationId xmlns:a16="http://schemas.microsoft.com/office/drawing/2014/main" id="{00C7296A-D9DB-6095-8AE8-00EC48F98E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4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1" name="Rectangle 416">
              <a:extLst>
                <a:ext uri="{FF2B5EF4-FFF2-40B4-BE49-F238E27FC236}">
                  <a16:creationId xmlns:a16="http://schemas.microsoft.com/office/drawing/2014/main" id="{C06F20DD-5806-9A07-7FEB-D44C20BA96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9" y="3065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2" name="Rectangle 417">
              <a:extLst>
                <a:ext uri="{FF2B5EF4-FFF2-40B4-BE49-F238E27FC236}">
                  <a16:creationId xmlns:a16="http://schemas.microsoft.com/office/drawing/2014/main" id="{6A56F64C-6482-8805-E11A-00070C8CC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2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3" name="Rectangle 418">
              <a:extLst>
                <a:ext uri="{FF2B5EF4-FFF2-40B4-BE49-F238E27FC236}">
                  <a16:creationId xmlns:a16="http://schemas.microsoft.com/office/drawing/2014/main" id="{D848407D-42C4-C258-F29B-E60939BDA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6" y="3065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4" name="Rectangle 419">
              <a:extLst>
                <a:ext uri="{FF2B5EF4-FFF2-40B4-BE49-F238E27FC236}">
                  <a16:creationId xmlns:a16="http://schemas.microsoft.com/office/drawing/2014/main" id="{2E3DE90D-361A-3D29-A63F-1DF97B0B3F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4" y="3065"/>
              <a:ext cx="236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</a:t>
              </a:r>
              <a:r>
                <a:rPr kumimoji="0" lang="ja-JP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≤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5" name="Rectangle 420">
              <a:extLst>
                <a:ext uri="{FF2B5EF4-FFF2-40B4-BE49-F238E27FC236}">
                  <a16:creationId xmlns:a16="http://schemas.microsoft.com/office/drawing/2014/main" id="{C3BA46A7-5061-D0AB-8882-CFE6C81BEA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302"/>
              <a:ext cx="62" cy="47"/>
            </a:xfrm>
            <a:prstGeom prst="rect">
              <a:avLst/>
            </a:prstGeom>
            <a:solidFill>
              <a:srgbClr val="DF536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6" name="Rectangle 421">
              <a:extLst>
                <a:ext uri="{FF2B5EF4-FFF2-40B4-BE49-F238E27FC236}">
                  <a16:creationId xmlns:a16="http://schemas.microsoft.com/office/drawing/2014/main" id="{194E1C8E-4542-B45B-669C-562A24EC3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302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7" name="Rectangle 422">
              <a:extLst>
                <a:ext uri="{FF2B5EF4-FFF2-40B4-BE49-F238E27FC236}">
                  <a16:creationId xmlns:a16="http://schemas.microsoft.com/office/drawing/2014/main" id="{5EF0172D-68B3-F91E-A67C-C5ACD501FC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587"/>
              <a:ext cx="62" cy="47"/>
            </a:xfrm>
            <a:prstGeom prst="rect">
              <a:avLst/>
            </a:prstGeom>
            <a:solidFill>
              <a:srgbClr val="61D04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8" name="Rectangle 423">
              <a:extLst>
                <a:ext uri="{FF2B5EF4-FFF2-40B4-BE49-F238E27FC236}">
                  <a16:creationId xmlns:a16="http://schemas.microsoft.com/office/drawing/2014/main" id="{D1C83FF8-B677-DE31-24B2-05ACBCB373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8" y="587"/>
              <a:ext cx="62" cy="4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442" name="Line 427">
              <a:extLst>
                <a:ext uri="{FF2B5EF4-FFF2-40B4-BE49-F238E27FC236}">
                  <a16:creationId xmlns:a16="http://schemas.microsoft.com/office/drawing/2014/main" id="{9483A5CA-3F8D-D50C-50C6-7237312AA5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81" y="525"/>
              <a:ext cx="0" cy="240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3" name="Line 428">
              <a:extLst>
                <a:ext uri="{FF2B5EF4-FFF2-40B4-BE49-F238E27FC236}">
                  <a16:creationId xmlns:a16="http://schemas.microsoft.com/office/drawing/2014/main" id="{D50460B4-4237-095F-49F1-543E816160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932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4" name="Line 429">
              <a:extLst>
                <a:ext uri="{FF2B5EF4-FFF2-40B4-BE49-F238E27FC236}">
                  <a16:creationId xmlns:a16="http://schemas.microsoft.com/office/drawing/2014/main" id="{4B5B26BC-D599-793B-90CB-18AC782D29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2330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5" name="Line 430">
              <a:extLst>
                <a:ext uri="{FF2B5EF4-FFF2-40B4-BE49-F238E27FC236}">
                  <a16:creationId xmlns:a16="http://schemas.microsoft.com/office/drawing/2014/main" id="{0F2C1780-F331-2489-0B3E-9C692B3C77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728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6" name="Line 431">
              <a:extLst>
                <a:ext uri="{FF2B5EF4-FFF2-40B4-BE49-F238E27FC236}">
                  <a16:creationId xmlns:a16="http://schemas.microsoft.com/office/drawing/2014/main" id="{3D3214E3-100B-05EB-7870-D4E789E1AF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1126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7" name="Line 432">
              <a:extLst>
                <a:ext uri="{FF2B5EF4-FFF2-40B4-BE49-F238E27FC236}">
                  <a16:creationId xmlns:a16="http://schemas.microsoft.com/office/drawing/2014/main" id="{67B8A106-87C7-FE71-68BB-990FBAA9AB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035" y="525"/>
              <a:ext cx="4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8" name="Rectangle 433">
              <a:extLst>
                <a:ext uri="{FF2B5EF4-FFF2-40B4-BE49-F238E27FC236}">
                  <a16:creationId xmlns:a16="http://schemas.microsoft.com/office/drawing/2014/main" id="{010FF281-E7B5-FAC0-0FC3-FA673F50D8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" y="2896"/>
              <a:ext cx="82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9" name="Rectangle 434">
              <a:extLst>
                <a:ext uri="{FF2B5EF4-FFF2-40B4-BE49-F238E27FC236}">
                  <a16:creationId xmlns:a16="http://schemas.microsoft.com/office/drawing/2014/main" id="{32A9AB45-F1DE-8075-4B49-73A9BBA04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2294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0" name="Rectangle 435">
              <a:extLst>
                <a:ext uri="{FF2B5EF4-FFF2-40B4-BE49-F238E27FC236}">
                  <a16:creationId xmlns:a16="http://schemas.microsoft.com/office/drawing/2014/main" id="{CB774894-AEB7-0C99-542C-3B03B5D8DB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692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1" name="Rectangle 436">
              <a:extLst>
                <a:ext uri="{FF2B5EF4-FFF2-40B4-BE49-F238E27FC236}">
                  <a16:creationId xmlns:a16="http://schemas.microsoft.com/office/drawing/2014/main" id="{5EC6CE4D-645A-8E5F-37A6-AEB9A7266A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1090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2" name="Rectangle 437">
              <a:extLst>
                <a:ext uri="{FF2B5EF4-FFF2-40B4-BE49-F238E27FC236}">
                  <a16:creationId xmlns:a16="http://schemas.microsoft.com/office/drawing/2014/main" id="{545A5F0C-EB01-E741-2CE5-1AE4A16CEB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489"/>
              <a:ext cx="134" cy="1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457" name="テキスト ボックス 456">
            <a:extLst>
              <a:ext uri="{FF2B5EF4-FFF2-40B4-BE49-F238E27FC236}">
                <a16:creationId xmlns:a16="http://schemas.microsoft.com/office/drawing/2014/main" id="{2821D34F-2BF4-07F4-F3CF-036D8CA11F6E}"/>
              </a:ext>
            </a:extLst>
          </p:cNvPr>
          <p:cNvSpPr txBox="1"/>
          <p:nvPr/>
        </p:nvSpPr>
        <p:spPr>
          <a:xfrm>
            <a:off x="894698" y="3546909"/>
            <a:ext cx="26538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WC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a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0.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8" name="テキスト ボックス 457">
            <a:extLst>
              <a:ext uri="{FF2B5EF4-FFF2-40B4-BE49-F238E27FC236}">
                <a16:creationId xmlns:a16="http://schemas.microsoft.com/office/drawing/2014/main" id="{61686ED7-866F-3F9D-B0B6-BBAEFC3F13E1}"/>
              </a:ext>
            </a:extLst>
          </p:cNvPr>
          <p:cNvSpPr txBox="1"/>
          <p:nvPr/>
        </p:nvSpPr>
        <p:spPr>
          <a:xfrm>
            <a:off x="4784059" y="3545284"/>
            <a:ext cx="26538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C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a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9" name="テキスト ボックス 458">
            <a:extLst>
              <a:ext uri="{FF2B5EF4-FFF2-40B4-BE49-F238E27FC236}">
                <a16:creationId xmlns:a16="http://schemas.microsoft.com/office/drawing/2014/main" id="{DE46E9CC-1AD1-5C8E-F4FE-78E8ADED388C}"/>
              </a:ext>
            </a:extLst>
          </p:cNvPr>
          <p:cNvSpPr txBox="1"/>
          <p:nvPr/>
        </p:nvSpPr>
        <p:spPr>
          <a:xfrm>
            <a:off x="6454480" y="909460"/>
            <a:ext cx="13647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</p:txBody>
      </p:sp>
      <p:sp>
        <p:nvSpPr>
          <p:cNvPr id="460" name="テキスト ボックス 459">
            <a:extLst>
              <a:ext uri="{FF2B5EF4-FFF2-40B4-BE49-F238E27FC236}">
                <a16:creationId xmlns:a16="http://schemas.microsoft.com/office/drawing/2014/main" id="{F264DDF8-A9C7-0D28-56A3-5760D5FF1AD7}"/>
              </a:ext>
            </a:extLst>
          </p:cNvPr>
          <p:cNvSpPr txBox="1"/>
          <p:nvPr/>
        </p:nvSpPr>
        <p:spPr>
          <a:xfrm>
            <a:off x="6457466" y="1140660"/>
            <a:ext cx="1257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</p:txBody>
      </p:sp>
      <p:sp>
        <p:nvSpPr>
          <p:cNvPr id="461" name="テキスト ボックス 460">
            <a:extLst>
              <a:ext uri="{FF2B5EF4-FFF2-40B4-BE49-F238E27FC236}">
                <a16:creationId xmlns:a16="http://schemas.microsoft.com/office/drawing/2014/main" id="{4EADC05C-41E2-450B-8A75-D1713B74BEEF}"/>
              </a:ext>
            </a:extLst>
          </p:cNvPr>
          <p:cNvSpPr txBox="1"/>
          <p:nvPr/>
        </p:nvSpPr>
        <p:spPr>
          <a:xfrm>
            <a:off x="2909466" y="3954071"/>
            <a:ext cx="13647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</p:txBody>
      </p:sp>
      <p:sp>
        <p:nvSpPr>
          <p:cNvPr id="462" name="テキスト ボックス 461">
            <a:extLst>
              <a:ext uri="{FF2B5EF4-FFF2-40B4-BE49-F238E27FC236}">
                <a16:creationId xmlns:a16="http://schemas.microsoft.com/office/drawing/2014/main" id="{EDC67804-8C34-BB94-8225-6CEF8E4ECB33}"/>
              </a:ext>
            </a:extLst>
          </p:cNvPr>
          <p:cNvSpPr txBox="1"/>
          <p:nvPr/>
        </p:nvSpPr>
        <p:spPr>
          <a:xfrm>
            <a:off x="2911961" y="4183876"/>
            <a:ext cx="1257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</p:txBody>
      </p:sp>
      <p:sp>
        <p:nvSpPr>
          <p:cNvPr id="463" name="テキスト ボックス 462">
            <a:extLst>
              <a:ext uri="{FF2B5EF4-FFF2-40B4-BE49-F238E27FC236}">
                <a16:creationId xmlns:a16="http://schemas.microsoft.com/office/drawing/2014/main" id="{01EF5DF7-46CA-8AD4-7487-D40FEFD05251}"/>
              </a:ext>
            </a:extLst>
          </p:cNvPr>
          <p:cNvSpPr txBox="1"/>
          <p:nvPr/>
        </p:nvSpPr>
        <p:spPr>
          <a:xfrm>
            <a:off x="6486384" y="3975860"/>
            <a:ext cx="13647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</p:txBody>
      </p:sp>
      <p:sp>
        <p:nvSpPr>
          <p:cNvPr id="464" name="テキスト ボックス 463">
            <a:extLst>
              <a:ext uri="{FF2B5EF4-FFF2-40B4-BE49-F238E27FC236}">
                <a16:creationId xmlns:a16="http://schemas.microsoft.com/office/drawing/2014/main" id="{59E3FBA2-7712-898A-3010-FA21BEB59655}"/>
              </a:ext>
            </a:extLst>
          </p:cNvPr>
          <p:cNvSpPr txBox="1"/>
          <p:nvPr/>
        </p:nvSpPr>
        <p:spPr>
          <a:xfrm>
            <a:off x="6488879" y="4205665"/>
            <a:ext cx="1257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</p:txBody>
      </p:sp>
      <p:sp>
        <p:nvSpPr>
          <p:cNvPr id="466" name="テキスト ボックス 465">
            <a:extLst>
              <a:ext uri="{FF2B5EF4-FFF2-40B4-BE49-F238E27FC236}">
                <a16:creationId xmlns:a16="http://schemas.microsoft.com/office/drawing/2014/main" id="{B46136ED-C5E7-4F9D-0E05-DC1C0F14DAAD}"/>
              </a:ext>
            </a:extLst>
          </p:cNvPr>
          <p:cNvSpPr txBox="1"/>
          <p:nvPr/>
        </p:nvSpPr>
        <p:spPr>
          <a:xfrm>
            <a:off x="1593027" y="3147985"/>
            <a:ext cx="117827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VFA change (%)</a:t>
            </a:r>
            <a:endParaRPr lang="ja-JP" altLang="en-US" sz="1100" dirty="0"/>
          </a:p>
        </p:txBody>
      </p:sp>
      <p:sp>
        <p:nvSpPr>
          <p:cNvPr id="467" name="テキスト ボックス 466">
            <a:extLst>
              <a:ext uri="{FF2B5EF4-FFF2-40B4-BE49-F238E27FC236}">
                <a16:creationId xmlns:a16="http://schemas.microsoft.com/office/drawing/2014/main" id="{697FF6C6-BC8B-C804-7A73-DEA89B28482C}"/>
              </a:ext>
            </a:extLst>
          </p:cNvPr>
          <p:cNvSpPr txBox="1"/>
          <p:nvPr/>
        </p:nvSpPr>
        <p:spPr>
          <a:xfrm>
            <a:off x="5459679" y="3153771"/>
            <a:ext cx="117827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VFA change (%)</a:t>
            </a:r>
            <a:endParaRPr lang="ja-JP" altLang="en-US" sz="1100" dirty="0"/>
          </a:p>
        </p:txBody>
      </p:sp>
      <p:sp>
        <p:nvSpPr>
          <p:cNvPr id="470" name="テキスト ボックス 469">
            <a:extLst>
              <a:ext uri="{FF2B5EF4-FFF2-40B4-BE49-F238E27FC236}">
                <a16:creationId xmlns:a16="http://schemas.microsoft.com/office/drawing/2014/main" id="{FC8C9554-917A-D732-DDA3-A073DA2231CC}"/>
              </a:ext>
            </a:extLst>
          </p:cNvPr>
          <p:cNvSpPr txBox="1"/>
          <p:nvPr/>
        </p:nvSpPr>
        <p:spPr>
          <a:xfrm>
            <a:off x="5365446" y="6522036"/>
            <a:ext cx="117827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WC change (%)</a:t>
            </a:r>
            <a:endParaRPr lang="ja-JP" altLang="en-US" sz="1100" dirty="0"/>
          </a:p>
        </p:txBody>
      </p:sp>
      <p:sp>
        <p:nvSpPr>
          <p:cNvPr id="471" name="テキスト ボックス 470">
            <a:extLst>
              <a:ext uri="{FF2B5EF4-FFF2-40B4-BE49-F238E27FC236}">
                <a16:creationId xmlns:a16="http://schemas.microsoft.com/office/drawing/2014/main" id="{EBC6B25F-914E-99DD-6A86-9BD7531E7765}"/>
              </a:ext>
            </a:extLst>
          </p:cNvPr>
          <p:cNvSpPr txBox="1"/>
          <p:nvPr/>
        </p:nvSpPr>
        <p:spPr>
          <a:xfrm>
            <a:off x="1772238" y="6523200"/>
            <a:ext cx="117827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WC change (%)</a:t>
            </a:r>
            <a:endParaRPr lang="ja-JP" altLang="en-US" sz="11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2CE2C05-0DA1-2E03-6D9E-F1BDCEB7FB75}"/>
              </a:ext>
            </a:extLst>
          </p:cNvPr>
          <p:cNvSpPr txBox="1"/>
          <p:nvPr/>
        </p:nvSpPr>
        <p:spPr>
          <a:xfrm rot="10800000">
            <a:off x="357137" y="757382"/>
            <a:ext cx="353943" cy="174229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tients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7725999-7599-B76F-B833-8EF17835A242}"/>
              </a:ext>
            </a:extLst>
          </p:cNvPr>
          <p:cNvSpPr txBox="1"/>
          <p:nvPr/>
        </p:nvSpPr>
        <p:spPr>
          <a:xfrm rot="10800000">
            <a:off x="4223319" y="757382"/>
            <a:ext cx="353943" cy="174229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tients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C3B68BA-8256-A0A0-4CC3-B82B20F3AC91}"/>
              </a:ext>
            </a:extLst>
          </p:cNvPr>
          <p:cNvSpPr txBox="1"/>
          <p:nvPr/>
        </p:nvSpPr>
        <p:spPr>
          <a:xfrm rot="10800000">
            <a:off x="354001" y="3975860"/>
            <a:ext cx="353943" cy="174229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tients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CA50FB9-A82A-FE5A-5D19-AD84B7192E1F}"/>
              </a:ext>
            </a:extLst>
          </p:cNvPr>
          <p:cNvSpPr txBox="1"/>
          <p:nvPr/>
        </p:nvSpPr>
        <p:spPr>
          <a:xfrm rot="10800000">
            <a:off x="4223319" y="3975860"/>
            <a:ext cx="353943" cy="174229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patients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3236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136</Words>
  <Application>Microsoft Office PowerPoint</Application>
  <PresentationFormat>ワイド画面</PresentationFormat>
  <Paragraphs>9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伊坂　哲哉</dc:creator>
  <cp:lastModifiedBy>伊坂　哲哉</cp:lastModifiedBy>
  <cp:revision>7</cp:revision>
  <dcterms:created xsi:type="dcterms:W3CDTF">2024-08-21T10:33:10Z</dcterms:created>
  <dcterms:modified xsi:type="dcterms:W3CDTF">2025-02-15T15:49:08Z</dcterms:modified>
</cp:coreProperties>
</file>